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drawings/drawing2.xml" ContentType="application/vnd.openxmlformats-officedocument.drawingml.chartshapes+xml"/>
  <Override PartName="/ppt/charts/chart3.xml" ContentType="application/vnd.openxmlformats-officedocument.drawingml.chart+xml"/>
  <Override PartName="/ppt/drawings/drawing3.xml" ContentType="application/vnd.openxmlformats-officedocument.drawingml.chartshapes+xml"/>
  <Override PartName="/ppt/charts/chart4.xml" ContentType="application/vnd.openxmlformats-officedocument.drawingml.chart+xml"/>
  <Override PartName="/ppt/drawings/drawing4.xml" ContentType="application/vnd.openxmlformats-officedocument.drawingml.chartshapes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7" r:id="rId2"/>
    <p:sldId id="258" r:id="rId3"/>
    <p:sldId id="259" r:id="rId4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68827" autoAdjust="0"/>
  </p:normalViewPr>
  <p:slideViewPr>
    <p:cSldViewPr>
      <p:cViewPr>
        <p:scale>
          <a:sx n="86" d="100"/>
          <a:sy n="86" d="100"/>
        </p:scale>
        <p:origin x="-684" y="22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Z:\home\kie\Documents\20140429-KCNN4-Inh-ECAR.xlsx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oleObject" Target="file:///Z:\home\kie\Documents\20140429-KCNN4-Inh-ECAR.xlsx" TargetMode="Externa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3.xml"/><Relationship Id="rId1" Type="http://schemas.openxmlformats.org/officeDocument/2006/relationships/oleObject" Target="file:///Z:\home\kie\Documents\backup\Seahorse\20150305-BXPC3-KCNN4.xlsx" TargetMode="Externa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4.xml"/><Relationship Id="rId1" Type="http://schemas.openxmlformats.org/officeDocument/2006/relationships/oleObject" Target="file:///Z:\home\kie\Documents\20140429-KCNN4-Inh-ECAR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Mia PaCa-2</a:t>
            </a:r>
          </a:p>
        </c:rich>
      </c:tx>
      <c:layout>
        <c:manualLayout>
          <c:xMode val="edge"/>
          <c:yMode val="edge"/>
          <c:x val="0.24365390134167542"/>
          <c:y val="8.7119471186897668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7007323044862444"/>
          <c:y val="0.36392287555694874"/>
          <c:w val="0.42872660606161223"/>
          <c:h val="0.36617080248038469"/>
        </c:manualLayout>
      </c:layout>
      <c:scatterChart>
        <c:scatterStyle val="lineMarker"/>
        <c:varyColors val="0"/>
        <c:ser>
          <c:idx val="0"/>
          <c:order val="0"/>
          <c:tx>
            <c:strRef>
              <c:f>'Y1 Data'!$B$30</c:f>
              <c:strCache>
                <c:ptCount val="1"/>
                <c:pt idx="0">
                  <c:v>10 μM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diamond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Y1 Data'!$B$50:$B$67</c:f>
                <c:numCache>
                  <c:formatCode>General</c:formatCode>
                  <c:ptCount val="18"/>
                  <c:pt idx="0">
                    <c:v>7.5597867468082498</c:v>
                  </c:pt>
                  <c:pt idx="1">
                    <c:v>7.6071704247809198</c:v>
                  </c:pt>
                  <c:pt idx="2">
                    <c:v>8.7304425199544902</c:v>
                  </c:pt>
                  <c:pt idx="3">
                    <c:v>13.2483768901979</c:v>
                  </c:pt>
                  <c:pt idx="4">
                    <c:v>5.6490301874854802</c:v>
                  </c:pt>
                  <c:pt idx="5">
                    <c:v>5.7334844469694</c:v>
                  </c:pt>
                  <c:pt idx="6">
                    <c:v>6.1951578840685597</c:v>
                  </c:pt>
                  <c:pt idx="7">
                    <c:v>6.9697742084895102</c:v>
                  </c:pt>
                  <c:pt idx="8">
                    <c:v>12.3196066088748</c:v>
                  </c:pt>
                  <c:pt idx="9">
                    <c:v>9.9446017886944507</c:v>
                  </c:pt>
                  <c:pt idx="10">
                    <c:v>10.7639375460019</c:v>
                  </c:pt>
                  <c:pt idx="11">
                    <c:v>11.5753232992137</c:v>
                  </c:pt>
                  <c:pt idx="12">
                    <c:v>12.03052758968</c:v>
                  </c:pt>
                  <c:pt idx="13">
                    <c:v>18.3840699593934</c:v>
                  </c:pt>
                  <c:pt idx="14">
                    <c:v>6.2802285025949596</c:v>
                  </c:pt>
                  <c:pt idx="15">
                    <c:v>6.5628170219927302</c:v>
                  </c:pt>
                  <c:pt idx="16">
                    <c:v>6.4918482466360503</c:v>
                  </c:pt>
                  <c:pt idx="17">
                    <c:v>6.3360522319208004</c:v>
                  </c:pt>
                </c:numCache>
              </c:numRef>
            </c:plus>
            <c:minus>
              <c:numRef>
                <c:f>'Y1 Data'!$B$50:$B$67</c:f>
                <c:numCache>
                  <c:formatCode>General</c:formatCode>
                  <c:ptCount val="18"/>
                  <c:pt idx="0">
                    <c:v>7.5597867468082498</c:v>
                  </c:pt>
                  <c:pt idx="1">
                    <c:v>7.6071704247809198</c:v>
                  </c:pt>
                  <c:pt idx="2">
                    <c:v>8.7304425199544902</c:v>
                  </c:pt>
                  <c:pt idx="3">
                    <c:v>13.2483768901979</c:v>
                  </c:pt>
                  <c:pt idx="4">
                    <c:v>5.6490301874854802</c:v>
                  </c:pt>
                  <c:pt idx="5">
                    <c:v>5.7334844469694</c:v>
                  </c:pt>
                  <c:pt idx="6">
                    <c:v>6.1951578840685597</c:v>
                  </c:pt>
                  <c:pt idx="7">
                    <c:v>6.9697742084895102</c:v>
                  </c:pt>
                  <c:pt idx="8">
                    <c:v>12.3196066088748</c:v>
                  </c:pt>
                  <c:pt idx="9">
                    <c:v>9.9446017886944507</c:v>
                  </c:pt>
                  <c:pt idx="10">
                    <c:v>10.7639375460019</c:v>
                  </c:pt>
                  <c:pt idx="11">
                    <c:v>11.5753232992137</c:v>
                  </c:pt>
                  <c:pt idx="12">
                    <c:v>12.03052758968</c:v>
                  </c:pt>
                  <c:pt idx="13">
                    <c:v>18.3840699593934</c:v>
                  </c:pt>
                  <c:pt idx="14">
                    <c:v>6.2802285025949596</c:v>
                  </c:pt>
                  <c:pt idx="15">
                    <c:v>6.5628170219927302</c:v>
                  </c:pt>
                  <c:pt idx="16">
                    <c:v>6.4918482466360503</c:v>
                  </c:pt>
                  <c:pt idx="17">
                    <c:v>6.3360522319208004</c:v>
                  </c:pt>
                </c:numCache>
              </c:numRef>
            </c:minus>
          </c:errBars>
          <c:xVal>
            <c:numRef>
              <c:f>'Y1 Data'!$A$31:$A$48</c:f>
              <c:numCache>
                <c:formatCode>0</c:formatCode>
                <c:ptCount val="18"/>
                <c:pt idx="0">
                  <c:v>1.88333333333333</c:v>
                </c:pt>
                <c:pt idx="1">
                  <c:v>9.6999999999999993</c:v>
                </c:pt>
                <c:pt idx="2">
                  <c:v>17.483333333333299</c:v>
                </c:pt>
                <c:pt idx="3">
                  <c:v>23.466666666666701</c:v>
                </c:pt>
                <c:pt idx="4">
                  <c:v>31.25</c:v>
                </c:pt>
                <c:pt idx="5">
                  <c:v>39.016666666666701</c:v>
                </c:pt>
                <c:pt idx="6">
                  <c:v>46.783333333333303</c:v>
                </c:pt>
                <c:pt idx="7">
                  <c:v>54.55</c:v>
                </c:pt>
                <c:pt idx="8">
                  <c:v>60.566666666666698</c:v>
                </c:pt>
                <c:pt idx="9">
                  <c:v>68.3333333333333</c:v>
                </c:pt>
                <c:pt idx="10">
                  <c:v>76.099999999999994</c:v>
                </c:pt>
                <c:pt idx="11">
                  <c:v>83.883333333333297</c:v>
                </c:pt>
                <c:pt idx="12">
                  <c:v>91.65</c:v>
                </c:pt>
                <c:pt idx="13">
                  <c:v>97.65</c:v>
                </c:pt>
                <c:pt idx="14">
                  <c:v>105.416666666667</c:v>
                </c:pt>
                <c:pt idx="15">
                  <c:v>113.2</c:v>
                </c:pt>
                <c:pt idx="16">
                  <c:v>120.966666666667</c:v>
                </c:pt>
                <c:pt idx="17">
                  <c:v>128.73333333333301</c:v>
                </c:pt>
              </c:numCache>
            </c:numRef>
          </c:xVal>
          <c:yVal>
            <c:numRef>
              <c:f>'Y1 Data'!$B$31:$B$48</c:f>
              <c:numCache>
                <c:formatCode>0</c:formatCode>
                <c:ptCount val="18"/>
                <c:pt idx="0">
                  <c:v>68.182579154234503</c:v>
                </c:pt>
                <c:pt idx="1">
                  <c:v>61.225039130210199</c:v>
                </c:pt>
                <c:pt idx="2">
                  <c:v>61.874476476484197</c:v>
                </c:pt>
                <c:pt idx="3">
                  <c:v>74.215043200224002</c:v>
                </c:pt>
                <c:pt idx="4">
                  <c:v>90.797354509570596</c:v>
                </c:pt>
                <c:pt idx="5">
                  <c:v>91.051441208185693</c:v>
                </c:pt>
                <c:pt idx="6">
                  <c:v>89.832532932877797</c:v>
                </c:pt>
                <c:pt idx="7">
                  <c:v>88.403640714479295</c:v>
                </c:pt>
                <c:pt idx="8">
                  <c:v>86.025533156244094</c:v>
                </c:pt>
                <c:pt idx="9">
                  <c:v>98.875204205908304</c:v>
                </c:pt>
                <c:pt idx="10">
                  <c:v>100.33077598560099</c:v>
                </c:pt>
                <c:pt idx="11">
                  <c:v>100.45476554402499</c:v>
                </c:pt>
                <c:pt idx="12">
                  <c:v>101.02525128103601</c:v>
                </c:pt>
                <c:pt idx="13">
                  <c:v>98.387446843045396</c:v>
                </c:pt>
                <c:pt idx="14">
                  <c:v>92.680919528614396</c:v>
                </c:pt>
                <c:pt idx="15">
                  <c:v>86.737234784064796</c:v>
                </c:pt>
                <c:pt idx="16">
                  <c:v>81.059459161752201</c:v>
                </c:pt>
                <c:pt idx="17">
                  <c:v>77.671445136379702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Y1 Data'!$C$30</c:f>
              <c:strCache>
                <c:ptCount val="1"/>
                <c:pt idx="0">
                  <c:v>3.16  μM</c:v>
                </c:pt>
              </c:strCache>
            </c:strRef>
          </c:tx>
          <c:spPr>
            <a:ln>
              <a:solidFill>
                <a:schemeClr val="tx1">
                  <a:lumMod val="75000"/>
                  <a:lumOff val="25000"/>
                </a:schemeClr>
              </a:solidFill>
            </a:ln>
          </c:spPr>
          <c:marker>
            <c:symbol val="circle"/>
            <c:size val="5"/>
            <c:spPr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chemeClr val="tx1">
                    <a:lumMod val="75000"/>
                    <a:lumOff val="25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Y1 Data'!$C$50:$C$67</c:f>
                <c:numCache>
                  <c:formatCode>General</c:formatCode>
                  <c:ptCount val="18"/>
                  <c:pt idx="0">
                    <c:v>2.6106887373846099</c:v>
                  </c:pt>
                  <c:pt idx="1">
                    <c:v>5.6237454221789198</c:v>
                  </c:pt>
                  <c:pt idx="2">
                    <c:v>3.1920852944103699</c:v>
                  </c:pt>
                  <c:pt idx="3">
                    <c:v>9.2473374614184696</c:v>
                  </c:pt>
                  <c:pt idx="4">
                    <c:v>4.4542964175184601</c:v>
                  </c:pt>
                  <c:pt idx="5">
                    <c:v>3.9346693060648601</c:v>
                  </c:pt>
                  <c:pt idx="6">
                    <c:v>3.9583842206423698</c:v>
                  </c:pt>
                  <c:pt idx="7">
                    <c:v>4.2835586369643401</c:v>
                  </c:pt>
                  <c:pt idx="8">
                    <c:v>11.271226060401</c:v>
                  </c:pt>
                  <c:pt idx="9">
                    <c:v>7.91673003382461</c:v>
                  </c:pt>
                  <c:pt idx="10">
                    <c:v>4.98114727443817</c:v>
                  </c:pt>
                  <c:pt idx="11">
                    <c:v>4.9261140483569497</c:v>
                  </c:pt>
                  <c:pt idx="12">
                    <c:v>5.4285426042893299</c:v>
                  </c:pt>
                  <c:pt idx="13">
                    <c:v>11.2835043302091</c:v>
                  </c:pt>
                  <c:pt idx="14">
                    <c:v>1.58197027017419</c:v>
                  </c:pt>
                  <c:pt idx="15">
                    <c:v>2.1246028444704299</c:v>
                  </c:pt>
                  <c:pt idx="16">
                    <c:v>2.1745011858619101</c:v>
                  </c:pt>
                  <c:pt idx="17">
                    <c:v>2.25409084093728</c:v>
                  </c:pt>
                </c:numCache>
              </c:numRef>
            </c:plus>
            <c:minus>
              <c:numRef>
                <c:f>'Y1 Data'!$C$50:$C$67</c:f>
                <c:numCache>
                  <c:formatCode>General</c:formatCode>
                  <c:ptCount val="18"/>
                  <c:pt idx="0">
                    <c:v>2.6106887373846099</c:v>
                  </c:pt>
                  <c:pt idx="1">
                    <c:v>5.6237454221789198</c:v>
                  </c:pt>
                  <c:pt idx="2">
                    <c:v>3.1920852944103699</c:v>
                  </c:pt>
                  <c:pt idx="3">
                    <c:v>9.2473374614184696</c:v>
                  </c:pt>
                  <c:pt idx="4">
                    <c:v>4.4542964175184601</c:v>
                  </c:pt>
                  <c:pt idx="5">
                    <c:v>3.9346693060648601</c:v>
                  </c:pt>
                  <c:pt idx="6">
                    <c:v>3.9583842206423698</c:v>
                  </c:pt>
                  <c:pt idx="7">
                    <c:v>4.2835586369643401</c:v>
                  </c:pt>
                  <c:pt idx="8">
                    <c:v>11.271226060401</c:v>
                  </c:pt>
                  <c:pt idx="9">
                    <c:v>7.91673003382461</c:v>
                  </c:pt>
                  <c:pt idx="10">
                    <c:v>4.98114727443817</c:v>
                  </c:pt>
                  <c:pt idx="11">
                    <c:v>4.9261140483569497</c:v>
                  </c:pt>
                  <c:pt idx="12">
                    <c:v>5.4285426042893299</c:v>
                  </c:pt>
                  <c:pt idx="13">
                    <c:v>11.2835043302091</c:v>
                  </c:pt>
                  <c:pt idx="14">
                    <c:v>1.58197027017419</c:v>
                  </c:pt>
                  <c:pt idx="15">
                    <c:v>2.1246028444704299</c:v>
                  </c:pt>
                  <c:pt idx="16">
                    <c:v>2.1745011858619101</c:v>
                  </c:pt>
                  <c:pt idx="17">
                    <c:v>2.25409084093728</c:v>
                  </c:pt>
                </c:numCache>
              </c:numRef>
            </c:minus>
            <c:spPr>
              <a:ln>
                <a:solidFill>
                  <a:schemeClr val="tx1">
                    <a:lumMod val="75000"/>
                    <a:lumOff val="25000"/>
                  </a:schemeClr>
                </a:solidFill>
              </a:ln>
            </c:spPr>
          </c:errBars>
          <c:xVal>
            <c:numRef>
              <c:f>'Y1 Data'!$A$31:$A$48</c:f>
              <c:numCache>
                <c:formatCode>0</c:formatCode>
                <c:ptCount val="18"/>
                <c:pt idx="0">
                  <c:v>1.88333333333333</c:v>
                </c:pt>
                <c:pt idx="1">
                  <c:v>9.6999999999999993</c:v>
                </c:pt>
                <c:pt idx="2">
                  <c:v>17.483333333333299</c:v>
                </c:pt>
                <c:pt idx="3">
                  <c:v>23.466666666666701</c:v>
                </c:pt>
                <c:pt idx="4">
                  <c:v>31.25</c:v>
                </c:pt>
                <c:pt idx="5">
                  <c:v>39.016666666666701</c:v>
                </c:pt>
                <c:pt idx="6">
                  <c:v>46.783333333333303</c:v>
                </c:pt>
                <c:pt idx="7">
                  <c:v>54.55</c:v>
                </c:pt>
                <c:pt idx="8">
                  <c:v>60.566666666666698</c:v>
                </c:pt>
                <c:pt idx="9">
                  <c:v>68.3333333333333</c:v>
                </c:pt>
                <c:pt idx="10">
                  <c:v>76.099999999999994</c:v>
                </c:pt>
                <c:pt idx="11">
                  <c:v>83.883333333333297</c:v>
                </c:pt>
                <c:pt idx="12">
                  <c:v>91.65</c:v>
                </c:pt>
                <c:pt idx="13">
                  <c:v>97.65</c:v>
                </c:pt>
                <c:pt idx="14">
                  <c:v>105.416666666667</c:v>
                </c:pt>
                <c:pt idx="15">
                  <c:v>113.2</c:v>
                </c:pt>
                <c:pt idx="16">
                  <c:v>120.966666666667</c:v>
                </c:pt>
                <c:pt idx="17">
                  <c:v>128.73333333333301</c:v>
                </c:pt>
              </c:numCache>
            </c:numRef>
          </c:xVal>
          <c:yVal>
            <c:numRef>
              <c:f>'Y1 Data'!$C$31:$C$48</c:f>
              <c:numCache>
                <c:formatCode>0</c:formatCode>
                <c:ptCount val="18"/>
                <c:pt idx="0">
                  <c:v>62.171101982775397</c:v>
                </c:pt>
                <c:pt idx="1">
                  <c:v>53.038603430269802</c:v>
                </c:pt>
                <c:pt idx="2">
                  <c:v>55.5271387983586</c:v>
                </c:pt>
                <c:pt idx="3">
                  <c:v>54.455086259766802</c:v>
                </c:pt>
                <c:pt idx="4">
                  <c:v>65.169997694921705</c:v>
                </c:pt>
                <c:pt idx="5">
                  <c:v>66.901465635113695</c:v>
                </c:pt>
                <c:pt idx="6">
                  <c:v>66.053463063423294</c:v>
                </c:pt>
                <c:pt idx="7">
                  <c:v>65.332495310186005</c:v>
                </c:pt>
                <c:pt idx="8">
                  <c:v>61.294648427289701</c:v>
                </c:pt>
                <c:pt idx="9">
                  <c:v>68.119979579191295</c:v>
                </c:pt>
                <c:pt idx="10">
                  <c:v>70.337148985372494</c:v>
                </c:pt>
                <c:pt idx="11">
                  <c:v>70.750728278216499</c:v>
                </c:pt>
                <c:pt idx="12">
                  <c:v>70.963510956986994</c:v>
                </c:pt>
                <c:pt idx="13">
                  <c:v>72.732548125753198</c:v>
                </c:pt>
                <c:pt idx="14">
                  <c:v>69.588523065511794</c:v>
                </c:pt>
                <c:pt idx="15">
                  <c:v>65.740922979943306</c:v>
                </c:pt>
                <c:pt idx="16">
                  <c:v>61.325077380765599</c:v>
                </c:pt>
                <c:pt idx="17">
                  <c:v>58.547476618088297</c:v>
                </c:pt>
              </c:numCache>
            </c:numRef>
          </c:yVal>
          <c:smooth val="0"/>
        </c:ser>
        <c:ser>
          <c:idx val="5"/>
          <c:order val="2"/>
          <c:tx>
            <c:strRef>
              <c:f>'Y1 Data'!$G$30</c:f>
              <c:strCache>
                <c:ptCount val="1"/>
                <c:pt idx="0">
                  <c:v>DMSO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square"/>
            <c:size val="5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Y1 Data'!$G$50:$G$67</c:f>
                <c:numCache>
                  <c:formatCode>General</c:formatCode>
                  <c:ptCount val="18"/>
                  <c:pt idx="0">
                    <c:v>7.5857252503526</c:v>
                  </c:pt>
                  <c:pt idx="1">
                    <c:v>8.1966364087858796</c:v>
                  </c:pt>
                  <c:pt idx="2">
                    <c:v>8.0826100906590206</c:v>
                  </c:pt>
                  <c:pt idx="3">
                    <c:v>7.9405882402743302</c:v>
                  </c:pt>
                  <c:pt idx="4">
                    <c:v>5.2446734825589996</c:v>
                  </c:pt>
                  <c:pt idx="5">
                    <c:v>3.6708980680660002</c:v>
                  </c:pt>
                  <c:pt idx="6">
                    <c:v>3.3655947951382998</c:v>
                  </c:pt>
                  <c:pt idx="7">
                    <c:v>3.7695569972754801</c:v>
                  </c:pt>
                  <c:pt idx="8">
                    <c:v>10.077864769053599</c:v>
                  </c:pt>
                  <c:pt idx="9">
                    <c:v>7.3461215821177399</c:v>
                  </c:pt>
                  <c:pt idx="10">
                    <c:v>6.5162170926701002</c:v>
                  </c:pt>
                  <c:pt idx="11">
                    <c:v>6.4940309977536304</c:v>
                  </c:pt>
                  <c:pt idx="12">
                    <c:v>7.0173977609454203</c:v>
                  </c:pt>
                  <c:pt idx="13">
                    <c:v>11.072746931348499</c:v>
                  </c:pt>
                  <c:pt idx="14">
                    <c:v>3.9144399216553301</c:v>
                  </c:pt>
                  <c:pt idx="15">
                    <c:v>3.0211849679646501</c:v>
                  </c:pt>
                  <c:pt idx="16">
                    <c:v>2.6406048887734901</c:v>
                  </c:pt>
                  <c:pt idx="17">
                    <c:v>2.7119406591025901</c:v>
                  </c:pt>
                </c:numCache>
              </c:numRef>
            </c:plus>
            <c:minus>
              <c:numRef>
                <c:f>'Y1 Data'!$G$50:$G$67</c:f>
                <c:numCache>
                  <c:formatCode>General</c:formatCode>
                  <c:ptCount val="18"/>
                  <c:pt idx="0">
                    <c:v>7.5857252503526</c:v>
                  </c:pt>
                  <c:pt idx="1">
                    <c:v>8.1966364087858796</c:v>
                  </c:pt>
                  <c:pt idx="2">
                    <c:v>8.0826100906590206</c:v>
                  </c:pt>
                  <c:pt idx="3">
                    <c:v>7.9405882402743302</c:v>
                  </c:pt>
                  <c:pt idx="4">
                    <c:v>5.2446734825589996</c:v>
                  </c:pt>
                  <c:pt idx="5">
                    <c:v>3.6708980680660002</c:v>
                  </c:pt>
                  <c:pt idx="6">
                    <c:v>3.3655947951382998</c:v>
                  </c:pt>
                  <c:pt idx="7">
                    <c:v>3.7695569972754801</c:v>
                  </c:pt>
                  <c:pt idx="8">
                    <c:v>10.077864769053599</c:v>
                  </c:pt>
                  <c:pt idx="9">
                    <c:v>7.3461215821177399</c:v>
                  </c:pt>
                  <c:pt idx="10">
                    <c:v>6.5162170926701002</c:v>
                  </c:pt>
                  <c:pt idx="11">
                    <c:v>6.4940309977536304</c:v>
                  </c:pt>
                  <c:pt idx="12">
                    <c:v>7.0173977609454203</c:v>
                  </c:pt>
                  <c:pt idx="13">
                    <c:v>11.072746931348499</c:v>
                  </c:pt>
                  <c:pt idx="14">
                    <c:v>3.9144399216553301</c:v>
                  </c:pt>
                  <c:pt idx="15">
                    <c:v>3.0211849679646501</c:v>
                  </c:pt>
                  <c:pt idx="16">
                    <c:v>2.6406048887734901</c:v>
                  </c:pt>
                  <c:pt idx="17">
                    <c:v>2.7119406591025901</c:v>
                  </c:pt>
                </c:numCache>
              </c:numRef>
            </c:minus>
            <c:spPr>
              <a:ln>
                <a:solidFill>
                  <a:schemeClr val="bg1">
                    <a:lumMod val="75000"/>
                  </a:schemeClr>
                </a:solidFill>
              </a:ln>
            </c:spPr>
          </c:errBars>
          <c:xVal>
            <c:numRef>
              <c:f>'Y1 Data'!$A$31:$A$48</c:f>
              <c:numCache>
                <c:formatCode>0</c:formatCode>
                <c:ptCount val="18"/>
                <c:pt idx="0">
                  <c:v>1.88333333333333</c:v>
                </c:pt>
                <c:pt idx="1">
                  <c:v>9.6999999999999993</c:v>
                </c:pt>
                <c:pt idx="2">
                  <c:v>17.483333333333299</c:v>
                </c:pt>
                <c:pt idx="3">
                  <c:v>23.466666666666701</c:v>
                </c:pt>
                <c:pt idx="4">
                  <c:v>31.25</c:v>
                </c:pt>
                <c:pt idx="5">
                  <c:v>39.016666666666701</c:v>
                </c:pt>
                <c:pt idx="6">
                  <c:v>46.783333333333303</c:v>
                </c:pt>
                <c:pt idx="7">
                  <c:v>54.55</c:v>
                </c:pt>
                <c:pt idx="8">
                  <c:v>60.566666666666698</c:v>
                </c:pt>
                <c:pt idx="9">
                  <c:v>68.3333333333333</c:v>
                </c:pt>
                <c:pt idx="10">
                  <c:v>76.099999999999994</c:v>
                </c:pt>
                <c:pt idx="11">
                  <c:v>83.883333333333297</c:v>
                </c:pt>
                <c:pt idx="12">
                  <c:v>91.65</c:v>
                </c:pt>
                <c:pt idx="13">
                  <c:v>97.65</c:v>
                </c:pt>
                <c:pt idx="14">
                  <c:v>105.416666666667</c:v>
                </c:pt>
                <c:pt idx="15">
                  <c:v>113.2</c:v>
                </c:pt>
                <c:pt idx="16">
                  <c:v>120.966666666667</c:v>
                </c:pt>
                <c:pt idx="17">
                  <c:v>128.73333333333301</c:v>
                </c:pt>
              </c:numCache>
            </c:numRef>
          </c:xVal>
          <c:yVal>
            <c:numRef>
              <c:f>'Y1 Data'!$G$31:$G$48</c:f>
              <c:numCache>
                <c:formatCode>0</c:formatCode>
                <c:ptCount val="18"/>
                <c:pt idx="0">
                  <c:v>64.218537036391595</c:v>
                </c:pt>
                <c:pt idx="1">
                  <c:v>54.566364042754998</c:v>
                </c:pt>
                <c:pt idx="2">
                  <c:v>54.638810846418103</c:v>
                </c:pt>
                <c:pt idx="3">
                  <c:v>54.1347595355466</c:v>
                </c:pt>
                <c:pt idx="4">
                  <c:v>58.659833630719099</c:v>
                </c:pt>
                <c:pt idx="5">
                  <c:v>56.048006674978303</c:v>
                </c:pt>
                <c:pt idx="6">
                  <c:v>54.110149201362198</c:v>
                </c:pt>
                <c:pt idx="7">
                  <c:v>51.8560207231398</c:v>
                </c:pt>
                <c:pt idx="8">
                  <c:v>50.298985057401701</c:v>
                </c:pt>
                <c:pt idx="9">
                  <c:v>52.667835967891897</c:v>
                </c:pt>
                <c:pt idx="10">
                  <c:v>51.297870062981502</c:v>
                </c:pt>
                <c:pt idx="11">
                  <c:v>50.238489784211502</c:v>
                </c:pt>
                <c:pt idx="12">
                  <c:v>49.847871463278601</c:v>
                </c:pt>
                <c:pt idx="13">
                  <c:v>59.542714767250501</c:v>
                </c:pt>
                <c:pt idx="14">
                  <c:v>51.900943257430598</c:v>
                </c:pt>
                <c:pt idx="15">
                  <c:v>47.145415277790903</c:v>
                </c:pt>
                <c:pt idx="16">
                  <c:v>43.828150446451701</c:v>
                </c:pt>
                <c:pt idx="17">
                  <c:v>41.67772890504220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8433152"/>
        <c:axId val="38435072"/>
      </c:scatterChart>
      <c:valAx>
        <c:axId val="38433152"/>
        <c:scaling>
          <c:orientation val="minMax"/>
        </c:scaling>
        <c:delete val="0"/>
        <c:axPos val="b"/>
        <c:title>
          <c:tx>
            <c:strRef>
              <c:f>'Y1 Data'!$A$30</c:f>
              <c:strCache>
                <c:ptCount val="1"/>
                <c:pt idx="0">
                  <c:v>Time (min)</c:v>
                </c:pt>
              </c:strCache>
            </c:strRef>
          </c:tx>
          <c:layout/>
          <c:overlay val="0"/>
          <c:txPr>
            <a:bodyPr/>
            <a:lstStyle/>
            <a:p>
              <a:pPr>
                <a:defRPr sz="1200"/>
              </a:pPr>
              <a:endParaRPr lang="de-DE"/>
            </a:p>
          </c:txPr>
        </c:title>
        <c:numFmt formatCode="0" sourceLinked="1"/>
        <c:majorTickMark val="out"/>
        <c:minorTickMark val="none"/>
        <c:tickLblPos val="nextTo"/>
        <c:crossAx val="38435072"/>
        <c:crosses val="autoZero"/>
        <c:crossBetween val="midCat"/>
      </c:valAx>
      <c:valAx>
        <c:axId val="38435072"/>
        <c:scaling>
          <c:orientation val="minMax"/>
        </c:scaling>
        <c:delete val="0"/>
        <c:axPos val="l"/>
        <c:title>
          <c:tx>
            <c:strRef>
              <c:f>'Y1 Data'!$B$6</c:f>
              <c:strCache>
                <c:ptCount val="1"/>
                <c:pt idx="0">
                  <c:v>ECAR (mpH/min)</c:v>
                </c:pt>
              </c:strCache>
            </c:strRef>
          </c:tx>
          <c:layout/>
          <c:overlay val="0"/>
          <c:txPr>
            <a:bodyPr rot="-5400000" vert="horz"/>
            <a:lstStyle/>
            <a:p>
              <a:pPr>
                <a:defRPr sz="1200"/>
              </a:pPr>
              <a:endParaRPr lang="de-DE"/>
            </a:p>
          </c:txPr>
        </c:title>
        <c:numFmt formatCode="0" sourceLinked="1"/>
        <c:majorTickMark val="out"/>
        <c:minorTickMark val="none"/>
        <c:tickLblPos val="nextTo"/>
        <c:crossAx val="38433152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'Y1 Data'!$R$29</c:f>
          <c:strCache>
            <c:ptCount val="1"/>
            <c:pt idx="0">
              <c:v>Capan-1</c:v>
            </c:pt>
          </c:strCache>
        </c:strRef>
      </c:tx>
      <c:layout>
        <c:manualLayout>
          <c:xMode val="edge"/>
          <c:yMode val="edge"/>
          <c:x val="0.17493152688250058"/>
          <c:y val="0.12029961234160354"/>
        </c:manualLayout>
      </c:layout>
      <c:overlay val="0"/>
      <c:txPr>
        <a:bodyPr/>
        <a:lstStyle/>
        <a:p>
          <a:pPr>
            <a:defRPr/>
          </a:pPr>
          <a:endParaRPr lang="de-DE"/>
        </a:p>
      </c:txPr>
    </c:title>
    <c:autoTitleDeleted val="0"/>
    <c:plotArea>
      <c:layout>
        <c:manualLayout>
          <c:layoutTarget val="inner"/>
          <c:xMode val="edge"/>
          <c:yMode val="edge"/>
          <c:x val="9.1002643697185567E-2"/>
          <c:y val="0.39878403851482075"/>
          <c:w val="0.31761139351863393"/>
          <c:h val="0.36518599077860847"/>
        </c:manualLayout>
      </c:layout>
      <c:scatterChart>
        <c:scatterStyle val="lineMarker"/>
        <c:varyColors val="0"/>
        <c:ser>
          <c:idx val="0"/>
          <c:order val="0"/>
          <c:tx>
            <c:strRef>
              <c:f>'Y1 Data'!$B$30</c:f>
              <c:strCache>
                <c:ptCount val="1"/>
                <c:pt idx="0">
                  <c:v>10 μM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diamond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Y1 Data'!$R$50:$R$67</c:f>
                <c:numCache>
                  <c:formatCode>General</c:formatCode>
                  <c:ptCount val="18"/>
                  <c:pt idx="0">
                    <c:v>2.3952152633190802</c:v>
                  </c:pt>
                  <c:pt idx="1">
                    <c:v>3.4302459826246801</c:v>
                  </c:pt>
                  <c:pt idx="2">
                    <c:v>1.85663101801368</c:v>
                  </c:pt>
                  <c:pt idx="3">
                    <c:v>2.0117599923113101</c:v>
                  </c:pt>
                  <c:pt idx="4">
                    <c:v>2.20884725960854</c:v>
                  </c:pt>
                  <c:pt idx="5">
                    <c:v>2.6922050226395902</c:v>
                  </c:pt>
                  <c:pt idx="6">
                    <c:v>2.66216930142958</c:v>
                  </c:pt>
                  <c:pt idx="7">
                    <c:v>2.4113260420603799</c:v>
                  </c:pt>
                  <c:pt idx="8">
                    <c:v>3.4695064135631499</c:v>
                  </c:pt>
                  <c:pt idx="9">
                    <c:v>2.09890052687483</c:v>
                  </c:pt>
                  <c:pt idx="10">
                    <c:v>2.1153773046858002</c:v>
                  </c:pt>
                  <c:pt idx="11">
                    <c:v>2.4044195521079201</c:v>
                  </c:pt>
                  <c:pt idx="12">
                    <c:v>2.20248975179826</c:v>
                  </c:pt>
                  <c:pt idx="13">
                    <c:v>1.37774575532713</c:v>
                  </c:pt>
                  <c:pt idx="14">
                    <c:v>3.86803769024919</c:v>
                  </c:pt>
                  <c:pt idx="15">
                    <c:v>3.6373194164449001</c:v>
                  </c:pt>
                  <c:pt idx="16">
                    <c:v>3.3170639665048598</c:v>
                  </c:pt>
                  <c:pt idx="17">
                    <c:v>3.18479399115841</c:v>
                  </c:pt>
                </c:numCache>
              </c:numRef>
            </c:plus>
            <c:minus>
              <c:numRef>
                <c:f>'Y1 Data'!$R$50:$R$67</c:f>
                <c:numCache>
                  <c:formatCode>General</c:formatCode>
                  <c:ptCount val="18"/>
                  <c:pt idx="0">
                    <c:v>2.3952152633190802</c:v>
                  </c:pt>
                  <c:pt idx="1">
                    <c:v>3.4302459826246801</c:v>
                  </c:pt>
                  <c:pt idx="2">
                    <c:v>1.85663101801368</c:v>
                  </c:pt>
                  <c:pt idx="3">
                    <c:v>2.0117599923113101</c:v>
                  </c:pt>
                  <c:pt idx="4">
                    <c:v>2.20884725960854</c:v>
                  </c:pt>
                  <c:pt idx="5">
                    <c:v>2.6922050226395902</c:v>
                  </c:pt>
                  <c:pt idx="6">
                    <c:v>2.66216930142958</c:v>
                  </c:pt>
                  <c:pt idx="7">
                    <c:v>2.4113260420603799</c:v>
                  </c:pt>
                  <c:pt idx="8">
                    <c:v>3.4695064135631499</c:v>
                  </c:pt>
                  <c:pt idx="9">
                    <c:v>2.09890052687483</c:v>
                  </c:pt>
                  <c:pt idx="10">
                    <c:v>2.1153773046858002</c:v>
                  </c:pt>
                  <c:pt idx="11">
                    <c:v>2.4044195521079201</c:v>
                  </c:pt>
                  <c:pt idx="12">
                    <c:v>2.20248975179826</c:v>
                  </c:pt>
                  <c:pt idx="13">
                    <c:v>1.37774575532713</c:v>
                  </c:pt>
                  <c:pt idx="14">
                    <c:v>3.86803769024919</c:v>
                  </c:pt>
                  <c:pt idx="15">
                    <c:v>3.6373194164449001</c:v>
                  </c:pt>
                  <c:pt idx="16">
                    <c:v>3.3170639665048598</c:v>
                  </c:pt>
                  <c:pt idx="17">
                    <c:v>3.18479399115841</c:v>
                  </c:pt>
                </c:numCache>
              </c:numRef>
            </c:minus>
          </c:errBars>
          <c:xVal>
            <c:numRef>
              <c:f>'Y1 Data'!$A$31:$A$48</c:f>
              <c:numCache>
                <c:formatCode>0</c:formatCode>
                <c:ptCount val="18"/>
                <c:pt idx="0">
                  <c:v>1.88333333333333</c:v>
                </c:pt>
                <c:pt idx="1">
                  <c:v>9.6999999999999993</c:v>
                </c:pt>
                <c:pt idx="2">
                  <c:v>17.483333333333299</c:v>
                </c:pt>
                <c:pt idx="3">
                  <c:v>23.466666666666701</c:v>
                </c:pt>
                <c:pt idx="4">
                  <c:v>31.25</c:v>
                </c:pt>
                <c:pt idx="5">
                  <c:v>39.016666666666701</c:v>
                </c:pt>
                <c:pt idx="6">
                  <c:v>46.783333333333303</c:v>
                </c:pt>
                <c:pt idx="7">
                  <c:v>54.55</c:v>
                </c:pt>
                <c:pt idx="8">
                  <c:v>60.566666666666698</c:v>
                </c:pt>
                <c:pt idx="9">
                  <c:v>68.3333333333333</c:v>
                </c:pt>
                <c:pt idx="10">
                  <c:v>76.099999999999994</c:v>
                </c:pt>
                <c:pt idx="11">
                  <c:v>83.883333333333297</c:v>
                </c:pt>
                <c:pt idx="12">
                  <c:v>91.65</c:v>
                </c:pt>
                <c:pt idx="13">
                  <c:v>97.65</c:v>
                </c:pt>
                <c:pt idx="14">
                  <c:v>105.416666666667</c:v>
                </c:pt>
                <c:pt idx="15">
                  <c:v>113.2</c:v>
                </c:pt>
                <c:pt idx="16">
                  <c:v>120.966666666667</c:v>
                </c:pt>
                <c:pt idx="17">
                  <c:v>128.73333333333301</c:v>
                </c:pt>
              </c:numCache>
            </c:numRef>
          </c:xVal>
          <c:yVal>
            <c:numRef>
              <c:f>'Y1 Data'!$R$31:$R$48</c:f>
              <c:numCache>
                <c:formatCode>0.00000</c:formatCode>
                <c:ptCount val="18"/>
                <c:pt idx="0">
                  <c:v>31.169756207729801</c:v>
                </c:pt>
                <c:pt idx="1">
                  <c:v>30.804887254166299</c:v>
                </c:pt>
                <c:pt idx="2">
                  <c:v>31.751773233112701</c:v>
                </c:pt>
                <c:pt idx="3">
                  <c:v>25.596089947954599</c:v>
                </c:pt>
                <c:pt idx="4">
                  <c:v>38.458436535199397</c:v>
                </c:pt>
                <c:pt idx="5">
                  <c:v>40.060376886471602</c:v>
                </c:pt>
                <c:pt idx="6">
                  <c:v>39.582781212707197</c:v>
                </c:pt>
                <c:pt idx="7">
                  <c:v>38.3653597980013</c:v>
                </c:pt>
                <c:pt idx="8">
                  <c:v>26.753078313351999</c:v>
                </c:pt>
                <c:pt idx="9">
                  <c:v>36.636665185876303</c:v>
                </c:pt>
                <c:pt idx="10">
                  <c:v>36.191008021202101</c:v>
                </c:pt>
                <c:pt idx="11">
                  <c:v>36.1932580751484</c:v>
                </c:pt>
                <c:pt idx="12">
                  <c:v>36.579705911058703</c:v>
                </c:pt>
                <c:pt idx="13">
                  <c:v>41.946414000596903</c:v>
                </c:pt>
                <c:pt idx="14">
                  <c:v>41.971288252551503</c:v>
                </c:pt>
                <c:pt idx="15">
                  <c:v>38.630662201133497</c:v>
                </c:pt>
                <c:pt idx="16">
                  <c:v>36.9633388250869</c:v>
                </c:pt>
                <c:pt idx="17">
                  <c:v>36.414648950532701</c:v>
                </c:pt>
              </c:numCache>
            </c:numRef>
          </c:yVal>
          <c:smooth val="0"/>
        </c:ser>
        <c:ser>
          <c:idx val="5"/>
          <c:order val="1"/>
          <c:tx>
            <c:strRef>
              <c:f>'Y1 Data'!$G$30</c:f>
              <c:strCache>
                <c:ptCount val="1"/>
                <c:pt idx="0">
                  <c:v>DMSO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square"/>
            <c:size val="5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Y1 Data'!$W$50:$W$67</c:f>
                <c:numCache>
                  <c:formatCode>General</c:formatCode>
                  <c:ptCount val="18"/>
                  <c:pt idx="0">
                    <c:v>2.5607932947502001</c:v>
                  </c:pt>
                  <c:pt idx="1">
                    <c:v>3.97571053411761</c:v>
                  </c:pt>
                  <c:pt idx="2">
                    <c:v>4.2671004541554698</c:v>
                  </c:pt>
                  <c:pt idx="3">
                    <c:v>1.0902812691689601</c:v>
                  </c:pt>
                  <c:pt idx="4">
                    <c:v>2.4574560610835698</c:v>
                  </c:pt>
                  <c:pt idx="5">
                    <c:v>2.54184173877099</c:v>
                  </c:pt>
                  <c:pt idx="6">
                    <c:v>2.0786697898562201</c:v>
                  </c:pt>
                  <c:pt idx="7">
                    <c:v>1.4499840365718999</c:v>
                  </c:pt>
                  <c:pt idx="8">
                    <c:v>3.1455109747075798</c:v>
                  </c:pt>
                  <c:pt idx="9">
                    <c:v>2.80789694289312</c:v>
                  </c:pt>
                  <c:pt idx="10">
                    <c:v>1.3770963588601199</c:v>
                  </c:pt>
                  <c:pt idx="11">
                    <c:v>1.56237309224761</c:v>
                  </c:pt>
                  <c:pt idx="12">
                    <c:v>1.94149880607064</c:v>
                  </c:pt>
                  <c:pt idx="13">
                    <c:v>2.2087372943132002</c:v>
                  </c:pt>
                  <c:pt idx="14">
                    <c:v>2.14848268432223</c:v>
                  </c:pt>
                  <c:pt idx="15">
                    <c:v>2.1985476223991398</c:v>
                  </c:pt>
                  <c:pt idx="16">
                    <c:v>2.1294108203151301</c:v>
                  </c:pt>
                  <c:pt idx="17">
                    <c:v>2.1818017750677399</c:v>
                  </c:pt>
                </c:numCache>
              </c:numRef>
            </c:plus>
            <c:minus>
              <c:numRef>
                <c:f>'Y1 Data'!$W$50:$W$67</c:f>
                <c:numCache>
                  <c:formatCode>General</c:formatCode>
                  <c:ptCount val="18"/>
                  <c:pt idx="0">
                    <c:v>2.5607932947502001</c:v>
                  </c:pt>
                  <c:pt idx="1">
                    <c:v>3.97571053411761</c:v>
                  </c:pt>
                  <c:pt idx="2">
                    <c:v>4.2671004541554698</c:v>
                  </c:pt>
                  <c:pt idx="3">
                    <c:v>1.0902812691689601</c:v>
                  </c:pt>
                  <c:pt idx="4">
                    <c:v>2.4574560610835698</c:v>
                  </c:pt>
                  <c:pt idx="5">
                    <c:v>2.54184173877099</c:v>
                  </c:pt>
                  <c:pt idx="6">
                    <c:v>2.0786697898562201</c:v>
                  </c:pt>
                  <c:pt idx="7">
                    <c:v>1.4499840365718999</c:v>
                  </c:pt>
                  <c:pt idx="8">
                    <c:v>3.1455109747075798</c:v>
                  </c:pt>
                  <c:pt idx="9">
                    <c:v>2.80789694289312</c:v>
                  </c:pt>
                  <c:pt idx="10">
                    <c:v>1.3770963588601199</c:v>
                  </c:pt>
                  <c:pt idx="11">
                    <c:v>1.56237309224761</c:v>
                  </c:pt>
                  <c:pt idx="12">
                    <c:v>1.94149880607064</c:v>
                  </c:pt>
                  <c:pt idx="13">
                    <c:v>2.2087372943132002</c:v>
                  </c:pt>
                  <c:pt idx="14">
                    <c:v>2.14848268432223</c:v>
                  </c:pt>
                  <c:pt idx="15">
                    <c:v>2.1985476223991398</c:v>
                  </c:pt>
                  <c:pt idx="16">
                    <c:v>2.1294108203151301</c:v>
                  </c:pt>
                  <c:pt idx="17">
                    <c:v>2.1818017750677399</c:v>
                  </c:pt>
                </c:numCache>
              </c:numRef>
            </c:minus>
            <c:spPr>
              <a:ln>
                <a:solidFill>
                  <a:schemeClr val="bg1">
                    <a:lumMod val="75000"/>
                  </a:schemeClr>
                </a:solidFill>
              </a:ln>
            </c:spPr>
          </c:errBars>
          <c:xVal>
            <c:numRef>
              <c:f>'Y1 Data'!$A$31:$A$48</c:f>
              <c:numCache>
                <c:formatCode>0</c:formatCode>
                <c:ptCount val="18"/>
                <c:pt idx="0">
                  <c:v>1.88333333333333</c:v>
                </c:pt>
                <c:pt idx="1">
                  <c:v>9.6999999999999993</c:v>
                </c:pt>
                <c:pt idx="2">
                  <c:v>17.483333333333299</c:v>
                </c:pt>
                <c:pt idx="3">
                  <c:v>23.466666666666701</c:v>
                </c:pt>
                <c:pt idx="4">
                  <c:v>31.25</c:v>
                </c:pt>
                <c:pt idx="5">
                  <c:v>39.016666666666701</c:v>
                </c:pt>
                <c:pt idx="6">
                  <c:v>46.783333333333303</c:v>
                </c:pt>
                <c:pt idx="7">
                  <c:v>54.55</c:v>
                </c:pt>
                <c:pt idx="8">
                  <c:v>60.566666666666698</c:v>
                </c:pt>
                <c:pt idx="9">
                  <c:v>68.3333333333333</c:v>
                </c:pt>
                <c:pt idx="10">
                  <c:v>76.099999999999994</c:v>
                </c:pt>
                <c:pt idx="11">
                  <c:v>83.883333333333297</c:v>
                </c:pt>
                <c:pt idx="12">
                  <c:v>91.65</c:v>
                </c:pt>
                <c:pt idx="13">
                  <c:v>97.65</c:v>
                </c:pt>
                <c:pt idx="14">
                  <c:v>105.416666666667</c:v>
                </c:pt>
                <c:pt idx="15">
                  <c:v>113.2</c:v>
                </c:pt>
                <c:pt idx="16">
                  <c:v>120.966666666667</c:v>
                </c:pt>
                <c:pt idx="17">
                  <c:v>128.73333333333301</c:v>
                </c:pt>
              </c:numCache>
            </c:numRef>
          </c:xVal>
          <c:yVal>
            <c:numRef>
              <c:f>'Y1 Data'!$W$31:$W$48</c:f>
              <c:numCache>
                <c:formatCode>0.00000</c:formatCode>
                <c:ptCount val="18"/>
                <c:pt idx="0">
                  <c:v>31.777412740550201</c:v>
                </c:pt>
                <c:pt idx="1">
                  <c:v>30.2237253473346</c:v>
                </c:pt>
                <c:pt idx="2">
                  <c:v>30.951856990949</c:v>
                </c:pt>
                <c:pt idx="3">
                  <c:v>27.694440773594401</c:v>
                </c:pt>
                <c:pt idx="4">
                  <c:v>36.006230125253801</c:v>
                </c:pt>
                <c:pt idx="5">
                  <c:v>37.704528434731898</c:v>
                </c:pt>
                <c:pt idx="6">
                  <c:v>37.575365443701898</c:v>
                </c:pt>
                <c:pt idx="7">
                  <c:v>36.198465237540702</c:v>
                </c:pt>
                <c:pt idx="8">
                  <c:v>27.0648673762424</c:v>
                </c:pt>
                <c:pt idx="9">
                  <c:v>33.633678984282099</c:v>
                </c:pt>
                <c:pt idx="10">
                  <c:v>34.3535289655808</c:v>
                </c:pt>
                <c:pt idx="11">
                  <c:v>34.1509446918541</c:v>
                </c:pt>
                <c:pt idx="12">
                  <c:v>34.395583152809998</c:v>
                </c:pt>
                <c:pt idx="13">
                  <c:v>42.659765848837999</c:v>
                </c:pt>
                <c:pt idx="14">
                  <c:v>39.873573456862701</c:v>
                </c:pt>
                <c:pt idx="15">
                  <c:v>37.051518841802903</c:v>
                </c:pt>
                <c:pt idx="16">
                  <c:v>35.8390746399702</c:v>
                </c:pt>
                <c:pt idx="17">
                  <c:v>35.59632042594530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8352384"/>
        <c:axId val="38354304"/>
      </c:scatterChart>
      <c:valAx>
        <c:axId val="38352384"/>
        <c:scaling>
          <c:orientation val="minMax"/>
        </c:scaling>
        <c:delete val="0"/>
        <c:axPos val="b"/>
        <c:title>
          <c:tx>
            <c:strRef>
              <c:f>'Y1 Data'!$A$30</c:f>
              <c:strCache>
                <c:ptCount val="1"/>
                <c:pt idx="0">
                  <c:v>Time (min)</c:v>
                </c:pt>
              </c:strCache>
            </c:strRef>
          </c:tx>
          <c:layout/>
          <c:overlay val="0"/>
          <c:txPr>
            <a:bodyPr/>
            <a:lstStyle/>
            <a:p>
              <a:pPr>
                <a:defRPr sz="1200"/>
              </a:pPr>
              <a:endParaRPr lang="de-DE"/>
            </a:p>
          </c:txPr>
        </c:title>
        <c:numFmt formatCode="0" sourceLinked="1"/>
        <c:majorTickMark val="out"/>
        <c:minorTickMark val="none"/>
        <c:tickLblPos val="nextTo"/>
        <c:crossAx val="38354304"/>
        <c:crosses val="autoZero"/>
        <c:crossBetween val="midCat"/>
      </c:valAx>
      <c:valAx>
        <c:axId val="38354304"/>
        <c:scaling>
          <c:orientation val="minMax"/>
        </c:scaling>
        <c:delete val="0"/>
        <c:axPos val="l"/>
        <c:title>
          <c:tx>
            <c:strRef>
              <c:f>'Y1 Data'!$B$6</c:f>
              <c:strCache>
                <c:ptCount val="1"/>
                <c:pt idx="0">
                  <c:v>ECAR (mpH/min)</c:v>
                </c:pt>
              </c:strCache>
            </c:strRef>
          </c:tx>
          <c:layout>
            <c:manualLayout>
              <c:xMode val="edge"/>
              <c:yMode val="edge"/>
              <c:x val="1.0798119936787068E-2"/>
              <c:y val="0.41161353039104476"/>
            </c:manualLayout>
          </c:layout>
          <c:overlay val="0"/>
          <c:txPr>
            <a:bodyPr rot="-5400000" vert="horz"/>
            <a:lstStyle/>
            <a:p>
              <a:pPr>
                <a:defRPr sz="1200"/>
              </a:pPr>
              <a:endParaRPr lang="de-DE"/>
            </a:p>
          </c:txPr>
        </c:title>
        <c:numFmt formatCode="0" sourceLinked="0"/>
        <c:majorTickMark val="out"/>
        <c:minorTickMark val="none"/>
        <c:tickLblPos val="nextTo"/>
        <c:crossAx val="38352384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BxPC-3</a:t>
            </a:r>
          </a:p>
        </c:rich>
      </c:tx>
      <c:layout>
        <c:manualLayout>
          <c:xMode val="edge"/>
          <c:yMode val="edge"/>
          <c:x val="0.32236272759793172"/>
          <c:y val="5.2619865598979028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6976664775663147"/>
          <c:y val="0.38564981383834845"/>
          <c:w val="0.48872602069022825"/>
          <c:h val="0.436012451607941"/>
        </c:manualLayout>
      </c:layout>
      <c:scatterChart>
        <c:scatterStyle val="lineMarker"/>
        <c:varyColors val="0"/>
        <c:ser>
          <c:idx val="0"/>
          <c:order val="0"/>
          <c:tx>
            <c:strRef>
              <c:f>'Rate (Plates)'!$O$144</c:f>
              <c:strCache>
                <c:ptCount val="1"/>
                <c:pt idx="0">
                  <c:v>10 μM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diamond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Rate (Plates)'!$P$151:$AA$151</c:f>
                <c:numCache>
                  <c:formatCode>General</c:formatCode>
                  <c:ptCount val="12"/>
                  <c:pt idx="0">
                    <c:v>7.850859240299453</c:v>
                  </c:pt>
                  <c:pt idx="1">
                    <c:v>9.8935393292485792</c:v>
                  </c:pt>
                  <c:pt idx="2">
                    <c:v>9.7389733249781774</c:v>
                  </c:pt>
                  <c:pt idx="3">
                    <c:v>8.9616303817644063</c:v>
                  </c:pt>
                  <c:pt idx="4">
                    <c:v>7.9515788775641418</c:v>
                  </c:pt>
                  <c:pt idx="5">
                    <c:v>7.6628270486604428</c:v>
                  </c:pt>
                  <c:pt idx="6">
                    <c:v>9.5134585195966093</c:v>
                  </c:pt>
                  <c:pt idx="7">
                    <c:v>8.1109442047652696</c:v>
                  </c:pt>
                  <c:pt idx="8">
                    <c:v>10.682222838852573</c:v>
                  </c:pt>
                  <c:pt idx="9">
                    <c:v>9.5759541655422442</c:v>
                  </c:pt>
                  <c:pt idx="10">
                    <c:v>6.1309771385180953</c:v>
                  </c:pt>
                  <c:pt idx="11">
                    <c:v>5.8533427397289266</c:v>
                  </c:pt>
                </c:numCache>
              </c:numRef>
            </c:plus>
            <c:minus>
              <c:numRef>
                <c:f>'Rate (Plates)'!$P$151:$AA$151</c:f>
                <c:numCache>
                  <c:formatCode>General</c:formatCode>
                  <c:ptCount val="12"/>
                  <c:pt idx="0">
                    <c:v>7.850859240299453</c:v>
                  </c:pt>
                  <c:pt idx="1">
                    <c:v>9.8935393292485792</c:v>
                  </c:pt>
                  <c:pt idx="2">
                    <c:v>9.7389733249781774</c:v>
                  </c:pt>
                  <c:pt idx="3">
                    <c:v>8.9616303817644063</c:v>
                  </c:pt>
                  <c:pt idx="4">
                    <c:v>7.9515788775641418</c:v>
                  </c:pt>
                  <c:pt idx="5">
                    <c:v>7.6628270486604428</c:v>
                  </c:pt>
                  <c:pt idx="6">
                    <c:v>9.5134585195966093</c:v>
                  </c:pt>
                  <c:pt idx="7">
                    <c:v>8.1109442047652696</c:v>
                  </c:pt>
                  <c:pt idx="8">
                    <c:v>10.682222838852573</c:v>
                  </c:pt>
                  <c:pt idx="9">
                    <c:v>9.5759541655422442</c:v>
                  </c:pt>
                  <c:pt idx="10">
                    <c:v>6.1309771385180953</c:v>
                  </c:pt>
                  <c:pt idx="11">
                    <c:v>5.8533427397289266</c:v>
                  </c:pt>
                </c:numCache>
              </c:numRef>
            </c:minus>
          </c:errBars>
          <c:xVal>
            <c:numRef>
              <c:f>'Rate (Plates)'!$P$143:$AA$143</c:f>
              <c:numCache>
                <c:formatCode>General</c:formatCode>
                <c:ptCount val="12"/>
                <c:pt idx="0">
                  <c:v>0</c:v>
                </c:pt>
                <c:pt idx="1">
                  <c:v>6</c:v>
                </c:pt>
                <c:pt idx="2">
                  <c:v>13</c:v>
                </c:pt>
                <c:pt idx="3">
                  <c:v>19</c:v>
                </c:pt>
                <c:pt idx="4">
                  <c:v>26</c:v>
                </c:pt>
                <c:pt idx="5">
                  <c:v>32</c:v>
                </c:pt>
                <c:pt idx="6">
                  <c:v>39</c:v>
                </c:pt>
                <c:pt idx="7">
                  <c:v>46</c:v>
                </c:pt>
                <c:pt idx="8">
                  <c:v>52</c:v>
                </c:pt>
                <c:pt idx="9">
                  <c:v>59</c:v>
                </c:pt>
                <c:pt idx="10">
                  <c:v>65</c:v>
                </c:pt>
                <c:pt idx="11">
                  <c:v>72</c:v>
                </c:pt>
              </c:numCache>
            </c:numRef>
          </c:xVal>
          <c:yVal>
            <c:numRef>
              <c:f>'Rate (Plates)'!$P$144:$AA$144</c:f>
              <c:numCache>
                <c:formatCode>0</c:formatCode>
                <c:ptCount val="12"/>
                <c:pt idx="0">
                  <c:v>68.761722604054341</c:v>
                </c:pt>
                <c:pt idx="1">
                  <c:v>61.362533487145427</c:v>
                </c:pt>
                <c:pt idx="2">
                  <c:v>63.492039067858073</c:v>
                </c:pt>
                <c:pt idx="3">
                  <c:v>87.449844893980156</c:v>
                </c:pt>
                <c:pt idx="4">
                  <c:v>87.374699062533224</c:v>
                </c:pt>
                <c:pt idx="5">
                  <c:v>85.828343642030902</c:v>
                </c:pt>
                <c:pt idx="6">
                  <c:v>88.7136340762206</c:v>
                </c:pt>
                <c:pt idx="7">
                  <c:v>86.806134980931944</c:v>
                </c:pt>
                <c:pt idx="8">
                  <c:v>83.285607076398065</c:v>
                </c:pt>
                <c:pt idx="9">
                  <c:v>123.36018661991349</c:v>
                </c:pt>
                <c:pt idx="10">
                  <c:v>93.55068953101177</c:v>
                </c:pt>
                <c:pt idx="11">
                  <c:v>85.451182391465323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Rate (Plates)'!$O$145</c:f>
              <c:strCache>
                <c:ptCount val="1"/>
                <c:pt idx="0">
                  <c:v>DMSO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square"/>
            <c:size val="5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Rate (Plates)'!$P$152:$AA$152</c:f>
                <c:numCache>
                  <c:formatCode>General</c:formatCode>
                  <c:ptCount val="12"/>
                  <c:pt idx="0">
                    <c:v>6.3393845631430885</c:v>
                  </c:pt>
                  <c:pt idx="1">
                    <c:v>6.1878893236494141</c:v>
                  </c:pt>
                  <c:pt idx="2">
                    <c:v>6.3403142584697454</c:v>
                  </c:pt>
                  <c:pt idx="3">
                    <c:v>6.2843689144618766</c:v>
                  </c:pt>
                  <c:pt idx="4">
                    <c:v>4.5525308820857369</c:v>
                  </c:pt>
                  <c:pt idx="5">
                    <c:v>4.5367771144880136</c:v>
                  </c:pt>
                  <c:pt idx="6">
                    <c:v>5.0205257411230164</c:v>
                  </c:pt>
                  <c:pt idx="7">
                    <c:v>5.3262931511216554</c:v>
                  </c:pt>
                  <c:pt idx="8">
                    <c:v>6.4055655447206279</c:v>
                  </c:pt>
                  <c:pt idx="9">
                    <c:v>6.318873839517531</c:v>
                  </c:pt>
                  <c:pt idx="10">
                    <c:v>4.1369479015813377</c:v>
                  </c:pt>
                  <c:pt idx="11">
                    <c:v>3.7212252855699464</c:v>
                  </c:pt>
                </c:numCache>
              </c:numRef>
            </c:plus>
            <c:minus>
              <c:numRef>
                <c:f>'Rate (Plates)'!$P$152:$AA$152</c:f>
                <c:numCache>
                  <c:formatCode>General</c:formatCode>
                  <c:ptCount val="12"/>
                  <c:pt idx="0">
                    <c:v>6.3393845631430885</c:v>
                  </c:pt>
                  <c:pt idx="1">
                    <c:v>6.1878893236494141</c:v>
                  </c:pt>
                  <c:pt idx="2">
                    <c:v>6.3403142584697454</c:v>
                  </c:pt>
                  <c:pt idx="3">
                    <c:v>6.2843689144618766</c:v>
                  </c:pt>
                  <c:pt idx="4">
                    <c:v>4.5525308820857369</c:v>
                  </c:pt>
                  <c:pt idx="5">
                    <c:v>4.5367771144880136</c:v>
                  </c:pt>
                  <c:pt idx="6">
                    <c:v>5.0205257411230164</c:v>
                  </c:pt>
                  <c:pt idx="7">
                    <c:v>5.3262931511216554</c:v>
                  </c:pt>
                  <c:pt idx="8">
                    <c:v>6.4055655447206279</c:v>
                  </c:pt>
                  <c:pt idx="9">
                    <c:v>6.318873839517531</c:v>
                  </c:pt>
                  <c:pt idx="10">
                    <c:v>4.1369479015813377</c:v>
                  </c:pt>
                  <c:pt idx="11">
                    <c:v>3.7212252855699464</c:v>
                  </c:pt>
                </c:numCache>
              </c:numRef>
            </c:minus>
            <c:spPr>
              <a:ln>
                <a:solidFill>
                  <a:schemeClr val="bg1">
                    <a:lumMod val="75000"/>
                  </a:schemeClr>
                </a:solidFill>
              </a:ln>
            </c:spPr>
          </c:errBars>
          <c:xVal>
            <c:numRef>
              <c:f>'Rate (Plates)'!$P$143:$AA$143</c:f>
              <c:numCache>
                <c:formatCode>General</c:formatCode>
                <c:ptCount val="12"/>
                <c:pt idx="0">
                  <c:v>0</c:v>
                </c:pt>
                <c:pt idx="1">
                  <c:v>6</c:v>
                </c:pt>
                <c:pt idx="2">
                  <c:v>13</c:v>
                </c:pt>
                <c:pt idx="3">
                  <c:v>19</c:v>
                </c:pt>
                <c:pt idx="4">
                  <c:v>26</c:v>
                </c:pt>
                <c:pt idx="5">
                  <c:v>32</c:v>
                </c:pt>
                <c:pt idx="6">
                  <c:v>39</c:v>
                </c:pt>
                <c:pt idx="7">
                  <c:v>46</c:v>
                </c:pt>
                <c:pt idx="8">
                  <c:v>52</c:v>
                </c:pt>
                <c:pt idx="9">
                  <c:v>59</c:v>
                </c:pt>
                <c:pt idx="10">
                  <c:v>65</c:v>
                </c:pt>
                <c:pt idx="11">
                  <c:v>72</c:v>
                </c:pt>
              </c:numCache>
            </c:numRef>
          </c:xVal>
          <c:yVal>
            <c:numRef>
              <c:f>'Rate (Plates)'!$P$145:$AA$145</c:f>
              <c:numCache>
                <c:formatCode>0</c:formatCode>
                <c:ptCount val="12"/>
                <c:pt idx="0">
                  <c:v>75.715488751904672</c:v>
                </c:pt>
                <c:pt idx="1">
                  <c:v>70.294007415274763</c:v>
                </c:pt>
                <c:pt idx="2">
                  <c:v>74.221995345325666</c:v>
                </c:pt>
                <c:pt idx="3">
                  <c:v>81.427262367514771</c:v>
                </c:pt>
                <c:pt idx="4">
                  <c:v>85.52220052519742</c:v>
                </c:pt>
                <c:pt idx="5">
                  <c:v>84.523287611638096</c:v>
                </c:pt>
                <c:pt idx="6">
                  <c:v>91.387025089325547</c:v>
                </c:pt>
                <c:pt idx="7">
                  <c:v>90.77038136453011</c:v>
                </c:pt>
                <c:pt idx="8">
                  <c:v>87.559992281594958</c:v>
                </c:pt>
                <c:pt idx="9">
                  <c:v>117.39157171625325</c:v>
                </c:pt>
                <c:pt idx="10">
                  <c:v>90.710173189833952</c:v>
                </c:pt>
                <c:pt idx="11">
                  <c:v>86.71747049332762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9307904"/>
        <c:axId val="221254784"/>
      </c:scatterChart>
      <c:valAx>
        <c:axId val="18930790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200"/>
                </a:pPr>
                <a:r>
                  <a:rPr lang="en-US" sz="1200"/>
                  <a:t>Time (min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21254784"/>
        <c:crosses val="autoZero"/>
        <c:crossBetween val="midCat"/>
      </c:valAx>
      <c:valAx>
        <c:axId val="22125478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/>
                </a:pPr>
                <a:r>
                  <a:rPr lang="en-US" sz="1200"/>
                  <a:t>ECAR (mpH/min)</a:t>
                </a:r>
              </a:p>
            </c:rich>
          </c:tx>
          <c:layout>
            <c:manualLayout>
              <c:xMode val="edge"/>
              <c:yMode val="edge"/>
              <c:x val="4.1745634130565965E-2"/>
              <c:y val="0.37074335045393819"/>
            </c:manualLayout>
          </c:layout>
          <c:overlay val="0"/>
        </c:title>
        <c:numFmt formatCode="0" sourceLinked="1"/>
        <c:majorTickMark val="out"/>
        <c:minorTickMark val="none"/>
        <c:tickLblPos val="nextTo"/>
        <c:crossAx val="189307904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'Y1 Data'!$J$29</c:f>
          <c:strCache>
            <c:ptCount val="1"/>
            <c:pt idx="0">
              <c:v>Panc-1</c:v>
            </c:pt>
          </c:strCache>
        </c:strRef>
      </c:tx>
      <c:layout>
        <c:manualLayout>
          <c:xMode val="edge"/>
          <c:yMode val="edge"/>
          <c:x val="0.27601492971820718"/>
          <c:y val="0.16917132985537997"/>
        </c:manualLayout>
      </c:layout>
      <c:overlay val="0"/>
      <c:txPr>
        <a:bodyPr/>
        <a:lstStyle/>
        <a:p>
          <a:pPr>
            <a:defRPr/>
          </a:pPr>
          <a:endParaRPr lang="de-DE"/>
        </a:p>
      </c:txPr>
    </c:title>
    <c:autoTitleDeleted val="0"/>
    <c:plotArea>
      <c:layout>
        <c:manualLayout>
          <c:layoutTarget val="inner"/>
          <c:xMode val="edge"/>
          <c:yMode val="edge"/>
          <c:x val="0.17363416255717137"/>
          <c:y val="0.4476557560285972"/>
          <c:w val="0.4479735489919473"/>
          <c:h val="0.36341109787604875"/>
        </c:manualLayout>
      </c:layout>
      <c:scatterChart>
        <c:scatterStyle val="lineMarker"/>
        <c:varyColors val="0"/>
        <c:ser>
          <c:idx val="0"/>
          <c:order val="0"/>
          <c:tx>
            <c:strRef>
              <c:f>'Y1 Data'!$B$30</c:f>
              <c:strCache>
                <c:ptCount val="1"/>
                <c:pt idx="0">
                  <c:v>10 μM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diamond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Y1 Data'!$J$50:$J$67</c:f>
                <c:numCache>
                  <c:formatCode>General</c:formatCode>
                  <c:ptCount val="18"/>
                  <c:pt idx="0">
                    <c:v>8.0377039306968605</c:v>
                  </c:pt>
                  <c:pt idx="1">
                    <c:v>5.6398118452295201</c:v>
                  </c:pt>
                  <c:pt idx="2">
                    <c:v>6.6836074523200697</c:v>
                  </c:pt>
                  <c:pt idx="3">
                    <c:v>9.9142668391329298</c:v>
                  </c:pt>
                  <c:pt idx="4">
                    <c:v>4.6571608806000899</c:v>
                  </c:pt>
                  <c:pt idx="5">
                    <c:v>2.5717741005232799</c:v>
                  </c:pt>
                  <c:pt idx="6">
                    <c:v>1.7395919162647799</c:v>
                  </c:pt>
                  <c:pt idx="7">
                    <c:v>1.4128700775029399</c:v>
                  </c:pt>
                  <c:pt idx="8">
                    <c:v>11.2946022837651</c:v>
                  </c:pt>
                  <c:pt idx="9">
                    <c:v>6.2124731050924797</c:v>
                  </c:pt>
                  <c:pt idx="10">
                    <c:v>7.5690586082601703</c:v>
                  </c:pt>
                  <c:pt idx="11">
                    <c:v>8.8465029126603003</c:v>
                  </c:pt>
                  <c:pt idx="12">
                    <c:v>8.1869702274965395</c:v>
                  </c:pt>
                  <c:pt idx="13">
                    <c:v>11.097926291805001</c:v>
                  </c:pt>
                  <c:pt idx="14">
                    <c:v>4.0426351678570001</c:v>
                  </c:pt>
                  <c:pt idx="15">
                    <c:v>3.3753437307280301</c:v>
                  </c:pt>
                  <c:pt idx="16">
                    <c:v>3.0709481204825302</c:v>
                  </c:pt>
                  <c:pt idx="17">
                    <c:v>2.9628405075538899</c:v>
                  </c:pt>
                </c:numCache>
              </c:numRef>
            </c:plus>
            <c:minus>
              <c:numRef>
                <c:f>'Y1 Data'!$J$50:$J$67</c:f>
                <c:numCache>
                  <c:formatCode>General</c:formatCode>
                  <c:ptCount val="18"/>
                  <c:pt idx="0">
                    <c:v>8.0377039306968605</c:v>
                  </c:pt>
                  <c:pt idx="1">
                    <c:v>5.6398118452295201</c:v>
                  </c:pt>
                  <c:pt idx="2">
                    <c:v>6.6836074523200697</c:v>
                  </c:pt>
                  <c:pt idx="3">
                    <c:v>9.9142668391329298</c:v>
                  </c:pt>
                  <c:pt idx="4">
                    <c:v>4.6571608806000899</c:v>
                  </c:pt>
                  <c:pt idx="5">
                    <c:v>2.5717741005232799</c:v>
                  </c:pt>
                  <c:pt idx="6">
                    <c:v>1.7395919162647799</c:v>
                  </c:pt>
                  <c:pt idx="7">
                    <c:v>1.4128700775029399</c:v>
                  </c:pt>
                  <c:pt idx="8">
                    <c:v>11.2946022837651</c:v>
                  </c:pt>
                  <c:pt idx="9">
                    <c:v>6.2124731050924797</c:v>
                  </c:pt>
                  <c:pt idx="10">
                    <c:v>7.5690586082601703</c:v>
                  </c:pt>
                  <c:pt idx="11">
                    <c:v>8.8465029126603003</c:v>
                  </c:pt>
                  <c:pt idx="12">
                    <c:v>8.1869702274965395</c:v>
                  </c:pt>
                  <c:pt idx="13">
                    <c:v>11.097926291805001</c:v>
                  </c:pt>
                  <c:pt idx="14">
                    <c:v>4.0426351678570001</c:v>
                  </c:pt>
                  <c:pt idx="15">
                    <c:v>3.3753437307280301</c:v>
                  </c:pt>
                  <c:pt idx="16">
                    <c:v>3.0709481204825302</c:v>
                  </c:pt>
                  <c:pt idx="17">
                    <c:v>2.9628405075538899</c:v>
                  </c:pt>
                </c:numCache>
              </c:numRef>
            </c:minus>
          </c:errBars>
          <c:xVal>
            <c:numRef>
              <c:f>'Y1 Data'!$A$31:$A$48</c:f>
              <c:numCache>
                <c:formatCode>0</c:formatCode>
                <c:ptCount val="18"/>
                <c:pt idx="0">
                  <c:v>1.88333333333333</c:v>
                </c:pt>
                <c:pt idx="1">
                  <c:v>9.6999999999999993</c:v>
                </c:pt>
                <c:pt idx="2">
                  <c:v>17.483333333333299</c:v>
                </c:pt>
                <c:pt idx="3">
                  <c:v>23.466666666666701</c:v>
                </c:pt>
                <c:pt idx="4">
                  <c:v>31.25</c:v>
                </c:pt>
                <c:pt idx="5">
                  <c:v>39.016666666666701</c:v>
                </c:pt>
                <c:pt idx="6">
                  <c:v>46.783333333333303</c:v>
                </c:pt>
                <c:pt idx="7">
                  <c:v>54.55</c:v>
                </c:pt>
                <c:pt idx="8">
                  <c:v>60.566666666666698</c:v>
                </c:pt>
                <c:pt idx="9">
                  <c:v>68.3333333333333</c:v>
                </c:pt>
                <c:pt idx="10">
                  <c:v>76.099999999999994</c:v>
                </c:pt>
                <c:pt idx="11">
                  <c:v>83.883333333333297</c:v>
                </c:pt>
                <c:pt idx="12">
                  <c:v>91.65</c:v>
                </c:pt>
                <c:pt idx="13">
                  <c:v>97.65</c:v>
                </c:pt>
                <c:pt idx="14">
                  <c:v>105.416666666667</c:v>
                </c:pt>
                <c:pt idx="15">
                  <c:v>113.2</c:v>
                </c:pt>
                <c:pt idx="16">
                  <c:v>120.966666666667</c:v>
                </c:pt>
                <c:pt idx="17">
                  <c:v>128.73333333333301</c:v>
                </c:pt>
              </c:numCache>
            </c:numRef>
          </c:xVal>
          <c:yVal>
            <c:numRef>
              <c:f>'Y1 Data'!$J$31:$J$48</c:f>
              <c:numCache>
                <c:formatCode>0.00000</c:formatCode>
                <c:ptCount val="18"/>
                <c:pt idx="0">
                  <c:v>66.075362706361105</c:v>
                </c:pt>
                <c:pt idx="1">
                  <c:v>57.697186775295201</c:v>
                </c:pt>
                <c:pt idx="2">
                  <c:v>57.637653204480202</c:v>
                </c:pt>
                <c:pt idx="3">
                  <c:v>54.513010179203</c:v>
                </c:pt>
                <c:pt idx="4">
                  <c:v>76.899620321055295</c:v>
                </c:pt>
                <c:pt idx="5">
                  <c:v>79.385310702150804</c:v>
                </c:pt>
                <c:pt idx="6">
                  <c:v>76.807218598214405</c:v>
                </c:pt>
                <c:pt idx="7">
                  <c:v>73.8721739659197</c:v>
                </c:pt>
                <c:pt idx="8">
                  <c:v>75.534619501096003</c:v>
                </c:pt>
                <c:pt idx="9">
                  <c:v>87.820380314452805</c:v>
                </c:pt>
                <c:pt idx="10">
                  <c:v>86.551853034084303</c:v>
                </c:pt>
                <c:pt idx="11">
                  <c:v>86.586295403842797</c:v>
                </c:pt>
                <c:pt idx="12">
                  <c:v>87.730285859728497</c:v>
                </c:pt>
                <c:pt idx="13">
                  <c:v>79.193939291362796</c:v>
                </c:pt>
                <c:pt idx="14">
                  <c:v>73.439385626767205</c:v>
                </c:pt>
                <c:pt idx="15">
                  <c:v>68.185518662425494</c:v>
                </c:pt>
                <c:pt idx="16">
                  <c:v>65.075028919022202</c:v>
                </c:pt>
                <c:pt idx="17">
                  <c:v>63.162974972694201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Y1 Data'!$C$30</c:f>
              <c:strCache>
                <c:ptCount val="1"/>
                <c:pt idx="0">
                  <c:v>3.16  μM</c:v>
                </c:pt>
              </c:strCache>
            </c:strRef>
          </c:tx>
          <c:spPr>
            <a:ln>
              <a:solidFill>
                <a:schemeClr val="tx1">
                  <a:lumMod val="75000"/>
                  <a:lumOff val="25000"/>
                </a:schemeClr>
              </a:solidFill>
            </a:ln>
          </c:spPr>
          <c:marker>
            <c:symbol val="circle"/>
            <c:size val="5"/>
            <c:spPr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chemeClr val="tx1">
                    <a:lumMod val="75000"/>
                    <a:lumOff val="25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Y1 Data'!$K$50:$K$67</c:f>
                <c:numCache>
                  <c:formatCode>General</c:formatCode>
                  <c:ptCount val="18"/>
                  <c:pt idx="0">
                    <c:v>5.6468202718240699</c:v>
                  </c:pt>
                  <c:pt idx="1">
                    <c:v>4.4458355944987504</c:v>
                  </c:pt>
                  <c:pt idx="2">
                    <c:v>4.9717016050265004</c:v>
                  </c:pt>
                  <c:pt idx="3">
                    <c:v>5.1967758170380502</c:v>
                  </c:pt>
                  <c:pt idx="4">
                    <c:v>8.2626071592676595</c:v>
                  </c:pt>
                  <c:pt idx="5">
                    <c:v>10.5988434688295</c:v>
                  </c:pt>
                  <c:pt idx="6">
                    <c:v>10.2841879495345</c:v>
                  </c:pt>
                  <c:pt idx="7">
                    <c:v>8.3789668288582302</c:v>
                  </c:pt>
                  <c:pt idx="8">
                    <c:v>3.2290354836922299</c:v>
                  </c:pt>
                  <c:pt idx="9">
                    <c:v>5.2857600338644497</c:v>
                  </c:pt>
                  <c:pt idx="10">
                    <c:v>4.7599563008513996</c:v>
                  </c:pt>
                  <c:pt idx="11">
                    <c:v>5.3908943108276102</c:v>
                  </c:pt>
                  <c:pt idx="12">
                    <c:v>5.83543631229991</c:v>
                  </c:pt>
                  <c:pt idx="13">
                    <c:v>5.2741816971751199</c:v>
                  </c:pt>
                  <c:pt idx="14">
                    <c:v>8.5336331300707204</c:v>
                  </c:pt>
                  <c:pt idx="15">
                    <c:v>7.7092824360682703</c:v>
                  </c:pt>
                  <c:pt idx="16">
                    <c:v>7.2368260249232597</c:v>
                  </c:pt>
                  <c:pt idx="17">
                    <c:v>6.7504466594567898</c:v>
                  </c:pt>
                </c:numCache>
              </c:numRef>
            </c:plus>
            <c:minus>
              <c:numRef>
                <c:f>'Y1 Data'!$K$50:$K$67</c:f>
                <c:numCache>
                  <c:formatCode>General</c:formatCode>
                  <c:ptCount val="18"/>
                  <c:pt idx="0">
                    <c:v>5.6468202718240699</c:v>
                  </c:pt>
                  <c:pt idx="1">
                    <c:v>4.4458355944987504</c:v>
                  </c:pt>
                  <c:pt idx="2">
                    <c:v>4.9717016050265004</c:v>
                  </c:pt>
                  <c:pt idx="3">
                    <c:v>5.1967758170380502</c:v>
                  </c:pt>
                  <c:pt idx="4">
                    <c:v>8.2626071592676595</c:v>
                  </c:pt>
                  <c:pt idx="5">
                    <c:v>10.5988434688295</c:v>
                  </c:pt>
                  <c:pt idx="6">
                    <c:v>10.2841879495345</c:v>
                  </c:pt>
                  <c:pt idx="7">
                    <c:v>8.3789668288582302</c:v>
                  </c:pt>
                  <c:pt idx="8">
                    <c:v>3.2290354836922299</c:v>
                  </c:pt>
                  <c:pt idx="9">
                    <c:v>5.2857600338644497</c:v>
                  </c:pt>
                  <c:pt idx="10">
                    <c:v>4.7599563008513996</c:v>
                  </c:pt>
                  <c:pt idx="11">
                    <c:v>5.3908943108276102</c:v>
                  </c:pt>
                  <c:pt idx="12">
                    <c:v>5.83543631229991</c:v>
                  </c:pt>
                  <c:pt idx="13">
                    <c:v>5.2741816971751199</c:v>
                  </c:pt>
                  <c:pt idx="14">
                    <c:v>8.5336331300707204</c:v>
                  </c:pt>
                  <c:pt idx="15">
                    <c:v>7.7092824360682703</c:v>
                  </c:pt>
                  <c:pt idx="16">
                    <c:v>7.2368260249232597</c:v>
                  </c:pt>
                  <c:pt idx="17">
                    <c:v>6.7504466594567898</c:v>
                  </c:pt>
                </c:numCache>
              </c:numRef>
            </c:minus>
          </c:errBars>
          <c:xVal>
            <c:numRef>
              <c:f>'Y1 Data'!$A$31:$A$48</c:f>
              <c:numCache>
                <c:formatCode>0</c:formatCode>
                <c:ptCount val="18"/>
                <c:pt idx="0">
                  <c:v>1.88333333333333</c:v>
                </c:pt>
                <c:pt idx="1">
                  <c:v>9.6999999999999993</c:v>
                </c:pt>
                <c:pt idx="2">
                  <c:v>17.483333333333299</c:v>
                </c:pt>
                <c:pt idx="3">
                  <c:v>23.466666666666701</c:v>
                </c:pt>
                <c:pt idx="4">
                  <c:v>31.25</c:v>
                </c:pt>
                <c:pt idx="5">
                  <c:v>39.016666666666701</c:v>
                </c:pt>
                <c:pt idx="6">
                  <c:v>46.783333333333303</c:v>
                </c:pt>
                <c:pt idx="7">
                  <c:v>54.55</c:v>
                </c:pt>
                <c:pt idx="8">
                  <c:v>60.566666666666698</c:v>
                </c:pt>
                <c:pt idx="9">
                  <c:v>68.3333333333333</c:v>
                </c:pt>
                <c:pt idx="10">
                  <c:v>76.099999999999994</c:v>
                </c:pt>
                <c:pt idx="11">
                  <c:v>83.883333333333297</c:v>
                </c:pt>
                <c:pt idx="12">
                  <c:v>91.65</c:v>
                </c:pt>
                <c:pt idx="13">
                  <c:v>97.65</c:v>
                </c:pt>
                <c:pt idx="14">
                  <c:v>105.416666666667</c:v>
                </c:pt>
                <c:pt idx="15">
                  <c:v>113.2</c:v>
                </c:pt>
                <c:pt idx="16">
                  <c:v>120.966666666667</c:v>
                </c:pt>
                <c:pt idx="17">
                  <c:v>128.73333333333301</c:v>
                </c:pt>
              </c:numCache>
            </c:numRef>
          </c:xVal>
          <c:yVal>
            <c:numRef>
              <c:f>'Y1 Data'!$K$31:$K$48</c:f>
              <c:numCache>
                <c:formatCode>General</c:formatCode>
                <c:ptCount val="18"/>
                <c:pt idx="0">
                  <c:v>71.744576205652606</c:v>
                </c:pt>
                <c:pt idx="1">
                  <c:v>58.070740060119597</c:v>
                </c:pt>
                <c:pt idx="2">
                  <c:v>57.789692746299202</c:v>
                </c:pt>
                <c:pt idx="3">
                  <c:v>58.913243771565902</c:v>
                </c:pt>
                <c:pt idx="4">
                  <c:v>64.923137154020907</c:v>
                </c:pt>
                <c:pt idx="5">
                  <c:v>64.701091215670104</c:v>
                </c:pt>
                <c:pt idx="6">
                  <c:v>63.083435783522802</c:v>
                </c:pt>
                <c:pt idx="7">
                  <c:v>62.747215729529898</c:v>
                </c:pt>
                <c:pt idx="8">
                  <c:v>77.060135433918106</c:v>
                </c:pt>
                <c:pt idx="9">
                  <c:v>76.434520286413402</c:v>
                </c:pt>
                <c:pt idx="10">
                  <c:v>73.337694658637105</c:v>
                </c:pt>
                <c:pt idx="11">
                  <c:v>72.768937388653001</c:v>
                </c:pt>
                <c:pt idx="12">
                  <c:v>73.214896217973205</c:v>
                </c:pt>
                <c:pt idx="13">
                  <c:v>68.215708216908496</c:v>
                </c:pt>
                <c:pt idx="14">
                  <c:v>61.335043733980697</c:v>
                </c:pt>
                <c:pt idx="15">
                  <c:v>56.4754655149125</c:v>
                </c:pt>
                <c:pt idx="16">
                  <c:v>53.570968241030499</c:v>
                </c:pt>
                <c:pt idx="17">
                  <c:v>52.392292022323701</c:v>
                </c:pt>
              </c:numCache>
            </c:numRef>
          </c:yVal>
          <c:smooth val="0"/>
        </c:ser>
        <c:ser>
          <c:idx val="5"/>
          <c:order val="2"/>
          <c:tx>
            <c:strRef>
              <c:f>'Y1 Data'!$G$30</c:f>
              <c:strCache>
                <c:ptCount val="1"/>
                <c:pt idx="0">
                  <c:v>DMSO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square"/>
            <c:size val="5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Y1 Data'!$O$50:$O$67</c:f>
                <c:numCache>
                  <c:formatCode>General</c:formatCode>
                  <c:ptCount val="18"/>
                  <c:pt idx="0">
                    <c:v>3.7863540506959001</c:v>
                  </c:pt>
                  <c:pt idx="1">
                    <c:v>0.577147710850199</c:v>
                  </c:pt>
                  <c:pt idx="2">
                    <c:v>0.30573177865307699</c:v>
                  </c:pt>
                  <c:pt idx="3">
                    <c:v>2.0112894164409498</c:v>
                  </c:pt>
                  <c:pt idx="4">
                    <c:v>1.6580639845371701</c:v>
                  </c:pt>
                  <c:pt idx="5">
                    <c:v>2.5824613300515602</c:v>
                  </c:pt>
                  <c:pt idx="6">
                    <c:v>2.88387434466931</c:v>
                  </c:pt>
                  <c:pt idx="7">
                    <c:v>2.6570412227731199</c:v>
                  </c:pt>
                  <c:pt idx="8">
                    <c:v>3.8572858537710402</c:v>
                  </c:pt>
                  <c:pt idx="9">
                    <c:v>1.9663149198339001</c:v>
                  </c:pt>
                  <c:pt idx="10">
                    <c:v>3.2676576095988299</c:v>
                  </c:pt>
                  <c:pt idx="11">
                    <c:v>4.1872716889341799</c:v>
                  </c:pt>
                  <c:pt idx="12">
                    <c:v>3.8967178742123898</c:v>
                  </c:pt>
                  <c:pt idx="13">
                    <c:v>4.3958741859273101</c:v>
                  </c:pt>
                  <c:pt idx="14">
                    <c:v>1.6037269179687901</c:v>
                  </c:pt>
                  <c:pt idx="15">
                    <c:v>1.5698466417258901</c:v>
                  </c:pt>
                  <c:pt idx="16">
                    <c:v>1.7226746019963699</c:v>
                  </c:pt>
                  <c:pt idx="17">
                    <c:v>1.47558736113453</c:v>
                  </c:pt>
                </c:numCache>
              </c:numRef>
            </c:plus>
            <c:minus>
              <c:numRef>
                <c:f>'Y1 Data'!$O$50:$O$67</c:f>
                <c:numCache>
                  <c:formatCode>General</c:formatCode>
                  <c:ptCount val="18"/>
                  <c:pt idx="0">
                    <c:v>3.7863540506959001</c:v>
                  </c:pt>
                  <c:pt idx="1">
                    <c:v>0.577147710850199</c:v>
                  </c:pt>
                  <c:pt idx="2">
                    <c:v>0.30573177865307699</c:v>
                  </c:pt>
                  <c:pt idx="3">
                    <c:v>2.0112894164409498</c:v>
                  </c:pt>
                  <c:pt idx="4">
                    <c:v>1.6580639845371701</c:v>
                  </c:pt>
                  <c:pt idx="5">
                    <c:v>2.5824613300515602</c:v>
                  </c:pt>
                  <c:pt idx="6">
                    <c:v>2.88387434466931</c:v>
                  </c:pt>
                  <c:pt idx="7">
                    <c:v>2.6570412227731199</c:v>
                  </c:pt>
                  <c:pt idx="8">
                    <c:v>3.8572858537710402</c:v>
                  </c:pt>
                  <c:pt idx="9">
                    <c:v>1.9663149198339001</c:v>
                  </c:pt>
                  <c:pt idx="10">
                    <c:v>3.2676576095988299</c:v>
                  </c:pt>
                  <c:pt idx="11">
                    <c:v>4.1872716889341799</c:v>
                  </c:pt>
                  <c:pt idx="12">
                    <c:v>3.8967178742123898</c:v>
                  </c:pt>
                  <c:pt idx="13">
                    <c:v>4.3958741859273101</c:v>
                  </c:pt>
                  <c:pt idx="14">
                    <c:v>1.6037269179687901</c:v>
                  </c:pt>
                  <c:pt idx="15">
                    <c:v>1.5698466417258901</c:v>
                  </c:pt>
                  <c:pt idx="16">
                    <c:v>1.7226746019963699</c:v>
                  </c:pt>
                  <c:pt idx="17">
                    <c:v>1.47558736113453</c:v>
                  </c:pt>
                </c:numCache>
              </c:numRef>
            </c:minus>
            <c:spPr>
              <a:ln>
                <a:solidFill>
                  <a:schemeClr val="bg1">
                    <a:lumMod val="75000"/>
                  </a:schemeClr>
                </a:solidFill>
              </a:ln>
            </c:spPr>
          </c:errBars>
          <c:xVal>
            <c:numRef>
              <c:f>'Y1 Data'!$A$31:$A$48</c:f>
              <c:numCache>
                <c:formatCode>0</c:formatCode>
                <c:ptCount val="18"/>
                <c:pt idx="0">
                  <c:v>1.88333333333333</c:v>
                </c:pt>
                <c:pt idx="1">
                  <c:v>9.6999999999999993</c:v>
                </c:pt>
                <c:pt idx="2">
                  <c:v>17.483333333333299</c:v>
                </c:pt>
                <c:pt idx="3">
                  <c:v>23.466666666666701</c:v>
                </c:pt>
                <c:pt idx="4">
                  <c:v>31.25</c:v>
                </c:pt>
                <c:pt idx="5">
                  <c:v>39.016666666666701</c:v>
                </c:pt>
                <c:pt idx="6">
                  <c:v>46.783333333333303</c:v>
                </c:pt>
                <c:pt idx="7">
                  <c:v>54.55</c:v>
                </c:pt>
                <c:pt idx="8">
                  <c:v>60.566666666666698</c:v>
                </c:pt>
                <c:pt idx="9">
                  <c:v>68.3333333333333</c:v>
                </c:pt>
                <c:pt idx="10">
                  <c:v>76.099999999999994</c:v>
                </c:pt>
                <c:pt idx="11">
                  <c:v>83.883333333333297</c:v>
                </c:pt>
                <c:pt idx="12">
                  <c:v>91.65</c:v>
                </c:pt>
                <c:pt idx="13">
                  <c:v>97.65</c:v>
                </c:pt>
                <c:pt idx="14">
                  <c:v>105.416666666667</c:v>
                </c:pt>
                <c:pt idx="15">
                  <c:v>113.2</c:v>
                </c:pt>
                <c:pt idx="16">
                  <c:v>120.966666666667</c:v>
                </c:pt>
                <c:pt idx="17">
                  <c:v>128.73333333333301</c:v>
                </c:pt>
              </c:numCache>
            </c:numRef>
          </c:xVal>
          <c:yVal>
            <c:numRef>
              <c:f>'Y1 Data'!$O$31:$O$48</c:f>
              <c:numCache>
                <c:formatCode>0.00000</c:formatCode>
                <c:ptCount val="18"/>
                <c:pt idx="0">
                  <c:v>65.2059524365973</c:v>
                </c:pt>
                <c:pt idx="1">
                  <c:v>54.028508539273403</c:v>
                </c:pt>
                <c:pt idx="2">
                  <c:v>55.339710398681397</c:v>
                </c:pt>
                <c:pt idx="3">
                  <c:v>49.4938431793272</c:v>
                </c:pt>
                <c:pt idx="4">
                  <c:v>63.126088679940601</c:v>
                </c:pt>
                <c:pt idx="5">
                  <c:v>62.130605165296402</c:v>
                </c:pt>
                <c:pt idx="6">
                  <c:v>61.7884166326686</c:v>
                </c:pt>
                <c:pt idx="7">
                  <c:v>61.335196131937302</c:v>
                </c:pt>
                <c:pt idx="8">
                  <c:v>51.325207999824798</c:v>
                </c:pt>
                <c:pt idx="9">
                  <c:v>62.407262552039398</c:v>
                </c:pt>
                <c:pt idx="10">
                  <c:v>64.855963461555802</c:v>
                </c:pt>
                <c:pt idx="11">
                  <c:v>65.9001810439525</c:v>
                </c:pt>
                <c:pt idx="12">
                  <c:v>66.033996800144095</c:v>
                </c:pt>
                <c:pt idx="13">
                  <c:v>62.531126409458402</c:v>
                </c:pt>
                <c:pt idx="14">
                  <c:v>61.0875455077121</c:v>
                </c:pt>
                <c:pt idx="15">
                  <c:v>57.297009975139098</c:v>
                </c:pt>
                <c:pt idx="16">
                  <c:v>54.698865264782697</c:v>
                </c:pt>
                <c:pt idx="17">
                  <c:v>53.47527125240760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21278592"/>
        <c:axId val="38792576"/>
      </c:scatterChart>
      <c:valAx>
        <c:axId val="221278592"/>
        <c:scaling>
          <c:orientation val="minMax"/>
        </c:scaling>
        <c:delete val="0"/>
        <c:axPos val="b"/>
        <c:title>
          <c:tx>
            <c:strRef>
              <c:f>'Y1 Data'!$A$30</c:f>
              <c:strCache>
                <c:ptCount val="1"/>
                <c:pt idx="0">
                  <c:v>Time (min)</c:v>
                </c:pt>
              </c:strCache>
            </c:strRef>
          </c:tx>
          <c:layout/>
          <c:overlay val="0"/>
          <c:txPr>
            <a:bodyPr/>
            <a:lstStyle/>
            <a:p>
              <a:pPr>
                <a:defRPr sz="1200"/>
              </a:pPr>
              <a:endParaRPr lang="de-DE"/>
            </a:p>
          </c:txPr>
        </c:title>
        <c:numFmt formatCode="0" sourceLinked="1"/>
        <c:majorTickMark val="out"/>
        <c:minorTickMark val="none"/>
        <c:tickLblPos val="nextTo"/>
        <c:crossAx val="38792576"/>
        <c:crosses val="autoZero"/>
        <c:crossBetween val="midCat"/>
      </c:valAx>
      <c:valAx>
        <c:axId val="38792576"/>
        <c:scaling>
          <c:orientation val="minMax"/>
        </c:scaling>
        <c:delete val="0"/>
        <c:axPos val="l"/>
        <c:title>
          <c:tx>
            <c:strRef>
              <c:f>'Y1 Data'!$B$6</c:f>
              <c:strCache>
                <c:ptCount val="1"/>
                <c:pt idx="0">
                  <c:v>ECAR (mpH/min)</c:v>
                </c:pt>
              </c:strCache>
            </c:strRef>
          </c:tx>
          <c:layout/>
          <c:overlay val="0"/>
          <c:txPr>
            <a:bodyPr rot="-5400000" vert="horz"/>
            <a:lstStyle/>
            <a:p>
              <a:pPr>
                <a:defRPr sz="1200"/>
              </a:pPr>
              <a:endParaRPr lang="de-DE"/>
            </a:p>
          </c:txPr>
        </c:title>
        <c:numFmt formatCode="0" sourceLinked="0"/>
        <c:majorTickMark val="out"/>
        <c:minorTickMark val="none"/>
        <c:tickLblPos val="nextTo"/>
        <c:crossAx val="221278592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8539</cdr:x>
      <cdr:y>0.17009</cdr:y>
    </cdr:from>
    <cdr:to>
      <cdr:x>0.56331</cdr:x>
      <cdr:y>0.30778</cdr:y>
    </cdr:to>
    <cdr:sp macro="" textlink="">
      <cdr:nvSpPr>
        <cdr:cNvPr id="8" name="TextBox 1"/>
        <cdr:cNvSpPr txBox="1"/>
      </cdr:nvSpPr>
      <cdr:spPr>
        <a:xfrm xmlns:a="http://schemas.openxmlformats.org/drawingml/2006/main">
          <a:off x="432048" y="570280"/>
          <a:ext cx="2418097" cy="461658"/>
        </a:xfrm>
        <a:prstGeom xmlns:a="http://schemas.openxmlformats.org/drawingml/2006/main" prst="rect">
          <a:avLst/>
        </a:prstGeom>
        <a:solidFill xmlns:a="http://schemas.openxmlformats.org/drawingml/2006/main">
          <a:schemeClr val="bg1"/>
        </a:solidFill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200" b="1" dirty="0"/>
            <a:t> </a:t>
          </a:r>
          <a:r>
            <a:rPr lang="en-US" sz="1200" b="1" dirty="0" smtClean="0"/>
            <a:t>           rac-16    NS309        </a:t>
          </a:r>
          <a:r>
            <a:rPr lang="en-US" sz="1200" b="1" dirty="0" err="1" smtClean="0"/>
            <a:t>KCl</a:t>
          </a:r>
          <a:r>
            <a:rPr lang="en-US" sz="1200" b="1" dirty="0" smtClean="0"/>
            <a:t>,</a:t>
          </a:r>
          <a:r>
            <a:rPr lang="de-DE" sz="1200" b="1" dirty="0" smtClean="0"/>
            <a:t> </a:t>
          </a:r>
        </a:p>
        <a:p xmlns:a="http://schemas.openxmlformats.org/drawingml/2006/main">
          <a:r>
            <a:rPr lang="de-DE" sz="1200" b="1" dirty="0" smtClean="0"/>
            <a:t>               </a:t>
          </a:r>
          <a:r>
            <a:rPr lang="de-DE" sz="1200" b="1" dirty="0"/>
            <a:t> </a:t>
          </a:r>
          <a:r>
            <a:rPr lang="de-DE" sz="1200" b="1" dirty="0" smtClean="0"/>
            <a:t>          100nM      </a:t>
          </a:r>
          <a:r>
            <a:rPr lang="de-DE" sz="1200" b="1" baseline="0" dirty="0" smtClean="0"/>
            <a:t>60mM</a:t>
          </a:r>
          <a:endParaRPr lang="de-DE" sz="1200" dirty="0">
            <a:effectLst/>
          </a:endParaRPr>
        </a:p>
      </cdr:txBody>
    </cdr:sp>
  </cdr:relSizeAnchor>
  <cdr:relSizeAnchor xmlns:cdr="http://schemas.openxmlformats.org/drawingml/2006/chartDrawing">
    <cdr:from>
      <cdr:x>0.22771</cdr:x>
      <cdr:y>0.29895</cdr:y>
    </cdr:from>
    <cdr:to>
      <cdr:x>0.22771</cdr:x>
      <cdr:y>0.73917</cdr:y>
    </cdr:to>
    <cdr:cxnSp macro="">
      <cdr:nvCxnSpPr>
        <cdr:cNvPr id="10" name="Straight Connector 9"/>
        <cdr:cNvCxnSpPr/>
      </cdr:nvCxnSpPr>
      <cdr:spPr>
        <a:xfrm xmlns:a="http://schemas.openxmlformats.org/drawingml/2006/main">
          <a:off x="1152128" y="1002328"/>
          <a:ext cx="0" cy="1476000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34156</cdr:x>
      <cdr:y>0.29895</cdr:y>
    </cdr:from>
    <cdr:to>
      <cdr:x>0.34156</cdr:x>
      <cdr:y>0.73917</cdr:y>
    </cdr:to>
    <cdr:cxnSp macro="">
      <cdr:nvCxnSpPr>
        <cdr:cNvPr id="11" name="Straight Connector 10"/>
        <cdr:cNvCxnSpPr/>
      </cdr:nvCxnSpPr>
      <cdr:spPr>
        <a:xfrm xmlns:a="http://schemas.openxmlformats.org/drawingml/2006/main">
          <a:off x="1728192" y="1002328"/>
          <a:ext cx="0" cy="1476000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44119</cdr:x>
      <cdr:y>0.29895</cdr:y>
    </cdr:from>
    <cdr:to>
      <cdr:x>0.44119</cdr:x>
      <cdr:y>0.73917</cdr:y>
    </cdr:to>
    <cdr:cxnSp macro="">
      <cdr:nvCxnSpPr>
        <cdr:cNvPr id="12" name="Straight Connector 11"/>
        <cdr:cNvCxnSpPr/>
      </cdr:nvCxnSpPr>
      <cdr:spPr>
        <a:xfrm xmlns:a="http://schemas.openxmlformats.org/drawingml/2006/main">
          <a:off x="2232248" y="1002328"/>
          <a:ext cx="0" cy="1476000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05102</cdr:x>
      <cdr:y>0.20635</cdr:y>
    </cdr:from>
    <cdr:to>
      <cdr:x>0.39368</cdr:x>
      <cdr:y>0.34301</cdr:y>
    </cdr:to>
    <cdr:sp macro="" textlink="">
      <cdr:nvSpPr>
        <cdr:cNvPr id="2" name="TextBox 7"/>
        <cdr:cNvSpPr txBox="1"/>
      </cdr:nvSpPr>
      <cdr:spPr>
        <a:xfrm xmlns:a="http://schemas.openxmlformats.org/drawingml/2006/main">
          <a:off x="360040" y="697096"/>
          <a:ext cx="2418097" cy="461658"/>
        </a:xfrm>
        <a:prstGeom xmlns:a="http://schemas.openxmlformats.org/drawingml/2006/main" prst="rect">
          <a:avLst/>
        </a:prstGeom>
        <a:solidFill xmlns:a="http://schemas.openxmlformats.org/drawingml/2006/main">
          <a:schemeClr val="bg1"/>
        </a:solidFill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200" b="1" dirty="0"/>
            <a:t> </a:t>
          </a:r>
          <a:r>
            <a:rPr lang="en-US" sz="1200" b="1" dirty="0" smtClean="0"/>
            <a:t>           rac-16    NS309        </a:t>
          </a:r>
          <a:r>
            <a:rPr lang="en-US" sz="1200" b="1" dirty="0" err="1" smtClean="0"/>
            <a:t>KCl</a:t>
          </a:r>
          <a:r>
            <a:rPr lang="en-US" sz="1200" b="1" dirty="0" smtClean="0"/>
            <a:t>,</a:t>
          </a:r>
          <a:r>
            <a:rPr lang="de-DE" sz="1200" b="1" dirty="0" smtClean="0"/>
            <a:t> </a:t>
          </a:r>
        </a:p>
        <a:p xmlns:a="http://schemas.openxmlformats.org/drawingml/2006/main">
          <a:r>
            <a:rPr lang="de-DE" sz="1200" b="1" dirty="0" smtClean="0"/>
            <a:t>               </a:t>
          </a:r>
          <a:r>
            <a:rPr lang="de-DE" sz="1200" b="1" dirty="0"/>
            <a:t> </a:t>
          </a:r>
          <a:r>
            <a:rPr lang="de-DE" sz="1200" b="1" dirty="0" smtClean="0"/>
            <a:t>          100nM      </a:t>
          </a:r>
          <a:r>
            <a:rPr lang="de-DE" sz="1200" b="1" baseline="0" dirty="0" smtClean="0"/>
            <a:t>60mM</a:t>
          </a:r>
          <a:endParaRPr lang="de-DE" sz="1200" dirty="0">
            <a:effectLst/>
          </a:endParaRPr>
        </a:p>
      </cdr:txBody>
    </cdr:sp>
  </cdr:relSizeAnchor>
  <cdr:relSizeAnchor xmlns:cdr="http://schemas.openxmlformats.org/drawingml/2006/chartDrawing">
    <cdr:from>
      <cdr:x>0.13265</cdr:x>
      <cdr:y>0.33641</cdr:y>
    </cdr:from>
    <cdr:to>
      <cdr:x>0.13265</cdr:x>
      <cdr:y>0.77333</cdr:y>
    </cdr:to>
    <cdr:cxnSp macro="">
      <cdr:nvCxnSpPr>
        <cdr:cNvPr id="9" name="Straight Connector 8"/>
        <cdr:cNvCxnSpPr/>
      </cdr:nvCxnSpPr>
      <cdr:spPr>
        <a:xfrm xmlns:a="http://schemas.openxmlformats.org/drawingml/2006/main">
          <a:off x="936104" y="1136480"/>
          <a:ext cx="0" cy="1476000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21429</cdr:x>
      <cdr:y>0.33641</cdr:y>
    </cdr:from>
    <cdr:to>
      <cdr:x>0.21429</cdr:x>
      <cdr:y>0.77333</cdr:y>
    </cdr:to>
    <cdr:cxnSp macro="">
      <cdr:nvCxnSpPr>
        <cdr:cNvPr id="10" name="Straight Connector 9"/>
        <cdr:cNvCxnSpPr/>
      </cdr:nvCxnSpPr>
      <cdr:spPr>
        <a:xfrm xmlns:a="http://schemas.openxmlformats.org/drawingml/2006/main">
          <a:off x="1512168" y="1136480"/>
          <a:ext cx="0" cy="1476000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29592</cdr:x>
      <cdr:y>0.33641</cdr:y>
    </cdr:from>
    <cdr:to>
      <cdr:x>0.29592</cdr:x>
      <cdr:y>0.77333</cdr:y>
    </cdr:to>
    <cdr:cxnSp macro="">
      <cdr:nvCxnSpPr>
        <cdr:cNvPr id="11" name="Straight Connector 10"/>
        <cdr:cNvCxnSpPr/>
      </cdr:nvCxnSpPr>
      <cdr:spPr>
        <a:xfrm xmlns:a="http://schemas.openxmlformats.org/drawingml/2006/main">
          <a:off x="2088232" y="1136480"/>
          <a:ext cx="0" cy="1476000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02041</cdr:x>
      <cdr:y>0.10194</cdr:y>
    </cdr:from>
    <cdr:to>
      <cdr:x>0.05364</cdr:x>
      <cdr:y>0.21127</cdr:y>
    </cdr:to>
    <cdr:sp macro="" textlink="">
      <cdr:nvSpPr>
        <cdr:cNvPr id="24" name="TextBox 1"/>
        <cdr:cNvSpPr txBox="1"/>
      </cdr:nvSpPr>
      <cdr:spPr>
        <a:xfrm xmlns:a="http://schemas.openxmlformats.org/drawingml/2006/main">
          <a:off x="144015" y="344392"/>
          <a:ext cx="234543" cy="36933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de-DE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800" b="1" dirty="0" smtClean="0"/>
            <a:t>C</a:t>
          </a:r>
          <a:endParaRPr lang="de-DE" sz="1800" b="1" dirty="0"/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11713</cdr:x>
      <cdr:y>0.14894</cdr:y>
    </cdr:from>
    <cdr:to>
      <cdr:x>0.66322</cdr:x>
      <cdr:y>0.31333</cdr:y>
    </cdr:to>
    <cdr:sp macro="" textlink="">
      <cdr:nvSpPr>
        <cdr:cNvPr id="8" name="TextBox 7"/>
        <cdr:cNvSpPr txBox="1"/>
      </cdr:nvSpPr>
      <cdr:spPr>
        <a:xfrm xmlns:a="http://schemas.openxmlformats.org/drawingml/2006/main">
          <a:off x="518635" y="418275"/>
          <a:ext cx="2418097" cy="461658"/>
        </a:xfrm>
        <a:prstGeom xmlns:a="http://schemas.openxmlformats.org/drawingml/2006/main" prst="rect">
          <a:avLst/>
        </a:prstGeom>
        <a:solidFill xmlns:a="http://schemas.openxmlformats.org/drawingml/2006/main">
          <a:schemeClr val="bg1"/>
        </a:solidFill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200" b="1" dirty="0"/>
            <a:t> </a:t>
          </a:r>
          <a:r>
            <a:rPr lang="en-US" sz="1200" b="1" dirty="0" smtClean="0"/>
            <a:t>           rac-16    NS309        </a:t>
          </a:r>
          <a:r>
            <a:rPr lang="en-US" sz="1200" b="1" dirty="0" err="1" smtClean="0"/>
            <a:t>KCl</a:t>
          </a:r>
          <a:r>
            <a:rPr lang="en-US" sz="1200" b="1" dirty="0" smtClean="0"/>
            <a:t>,</a:t>
          </a:r>
          <a:r>
            <a:rPr lang="de-DE" sz="1200" b="1" dirty="0" smtClean="0"/>
            <a:t> </a:t>
          </a:r>
        </a:p>
        <a:p xmlns:a="http://schemas.openxmlformats.org/drawingml/2006/main">
          <a:r>
            <a:rPr lang="de-DE" sz="1200" b="1" dirty="0" smtClean="0"/>
            <a:t>               </a:t>
          </a:r>
          <a:r>
            <a:rPr lang="de-DE" sz="1200" b="1" dirty="0"/>
            <a:t> </a:t>
          </a:r>
          <a:r>
            <a:rPr lang="de-DE" sz="1200" b="1" dirty="0" smtClean="0"/>
            <a:t>          100nM      </a:t>
          </a:r>
          <a:r>
            <a:rPr lang="de-DE" sz="1200" b="1" baseline="0" dirty="0" smtClean="0"/>
            <a:t>60mM</a:t>
          </a:r>
          <a:endParaRPr lang="de-DE" sz="1200" dirty="0">
            <a:effectLst/>
          </a:endParaRPr>
        </a:p>
      </cdr:txBody>
    </cdr:sp>
  </cdr:relSizeAnchor>
  <cdr:relSizeAnchor xmlns:cdr="http://schemas.openxmlformats.org/drawingml/2006/chartDrawing">
    <cdr:from>
      <cdr:x>0.25195</cdr:x>
      <cdr:y>0.30769</cdr:y>
    </cdr:from>
    <cdr:to>
      <cdr:x>0.25195</cdr:x>
      <cdr:y>0.83327</cdr:y>
    </cdr:to>
    <cdr:cxnSp macro="">
      <cdr:nvCxnSpPr>
        <cdr:cNvPr id="10" name="Straight Connector 9"/>
        <cdr:cNvCxnSpPr/>
      </cdr:nvCxnSpPr>
      <cdr:spPr>
        <a:xfrm xmlns:a="http://schemas.openxmlformats.org/drawingml/2006/main">
          <a:off x="1115616" y="864096"/>
          <a:ext cx="0" cy="1476000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38204</cdr:x>
      <cdr:y>0.30769</cdr:y>
    </cdr:from>
    <cdr:to>
      <cdr:x>0.38204</cdr:x>
      <cdr:y>0.83327</cdr:y>
    </cdr:to>
    <cdr:cxnSp macro="">
      <cdr:nvCxnSpPr>
        <cdr:cNvPr id="11" name="Straight Connector 10"/>
        <cdr:cNvCxnSpPr/>
      </cdr:nvCxnSpPr>
      <cdr:spPr>
        <a:xfrm xmlns:a="http://schemas.openxmlformats.org/drawingml/2006/main">
          <a:off x="1691680" y="864096"/>
          <a:ext cx="0" cy="1476000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51214</cdr:x>
      <cdr:y>0.30769</cdr:y>
    </cdr:from>
    <cdr:to>
      <cdr:x>0.51214</cdr:x>
      <cdr:y>0.83327</cdr:y>
    </cdr:to>
    <cdr:cxnSp macro="">
      <cdr:nvCxnSpPr>
        <cdr:cNvPr id="12" name="Straight Connector 11"/>
        <cdr:cNvCxnSpPr/>
      </cdr:nvCxnSpPr>
      <cdr:spPr>
        <a:xfrm xmlns:a="http://schemas.openxmlformats.org/drawingml/2006/main">
          <a:off x="2267744" y="864096"/>
          <a:ext cx="0" cy="1476000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</cdr:x>
      <cdr:y>1</cdr:y>
    </cdr:from>
    <cdr:to>
      <cdr:x>1</cdr:x>
      <cdr:y>1</cdr:y>
    </cdr:to>
    <cdr:cxnSp macro="">
      <cdr:nvCxnSpPr>
        <cdr:cNvPr id="12" name="Straight Connector 11"/>
        <cdr:cNvCxnSpPr/>
      </cdr:nvCxnSpPr>
      <cdr:spPr>
        <a:xfrm xmlns:a="http://schemas.openxmlformats.org/drawingml/2006/main">
          <a:off x="-417760" y="3911848"/>
          <a:ext cx="10297144" cy="0"/>
        </a:xfrm>
        <a:prstGeom xmlns:a="http://schemas.openxmlformats.org/drawingml/2006/main" prst="line">
          <a:avLst/>
        </a:prstGeom>
        <a:ln xmlns:a="http://schemas.openxmlformats.org/drawingml/2006/main">
          <a:noFill/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1155</cdr:x>
      <cdr:y>0.24702</cdr:y>
    </cdr:from>
    <cdr:to>
      <cdr:x>0.60032</cdr:x>
      <cdr:y>0.38368</cdr:y>
    </cdr:to>
    <cdr:sp macro="" textlink="">
      <cdr:nvSpPr>
        <cdr:cNvPr id="15" name="TextBox 1"/>
        <cdr:cNvSpPr txBox="1"/>
      </cdr:nvSpPr>
      <cdr:spPr>
        <a:xfrm xmlns:a="http://schemas.openxmlformats.org/drawingml/2006/main">
          <a:off x="576064" y="834486"/>
          <a:ext cx="2418097" cy="461658"/>
        </a:xfrm>
        <a:prstGeom xmlns:a="http://schemas.openxmlformats.org/drawingml/2006/main" prst="rect">
          <a:avLst/>
        </a:prstGeom>
        <a:solidFill xmlns:a="http://schemas.openxmlformats.org/drawingml/2006/main">
          <a:schemeClr val="bg1"/>
        </a:solidFill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200" b="1" dirty="0"/>
            <a:t> </a:t>
          </a:r>
          <a:r>
            <a:rPr lang="en-US" sz="1200" b="1" dirty="0" smtClean="0"/>
            <a:t>           rac-16    NS309        </a:t>
          </a:r>
          <a:r>
            <a:rPr lang="en-US" sz="1200" b="1" dirty="0" err="1" smtClean="0"/>
            <a:t>KCl</a:t>
          </a:r>
          <a:r>
            <a:rPr lang="en-US" sz="1200" b="1" dirty="0" smtClean="0"/>
            <a:t>,</a:t>
          </a:r>
          <a:r>
            <a:rPr lang="de-DE" sz="1200" b="1" dirty="0" smtClean="0"/>
            <a:t> </a:t>
          </a:r>
        </a:p>
        <a:p xmlns:a="http://schemas.openxmlformats.org/drawingml/2006/main">
          <a:r>
            <a:rPr lang="de-DE" sz="1200" b="1" dirty="0" smtClean="0"/>
            <a:t>               </a:t>
          </a:r>
          <a:r>
            <a:rPr lang="de-DE" sz="1200" b="1" dirty="0"/>
            <a:t> </a:t>
          </a:r>
          <a:r>
            <a:rPr lang="de-DE" sz="1200" b="1" dirty="0" smtClean="0"/>
            <a:t>          100nM      </a:t>
          </a:r>
          <a:r>
            <a:rPr lang="de-DE" sz="1200" b="1" baseline="0" dirty="0" smtClean="0"/>
            <a:t>60mM</a:t>
          </a:r>
          <a:endParaRPr lang="de-DE" sz="1200" dirty="0">
            <a:effectLst/>
          </a:endParaRPr>
        </a:p>
      </cdr:txBody>
    </cdr:sp>
  </cdr:relSizeAnchor>
  <cdr:relSizeAnchor xmlns:cdr="http://schemas.openxmlformats.org/drawingml/2006/chartDrawing">
    <cdr:from>
      <cdr:x>0.231</cdr:x>
      <cdr:y>0.38368</cdr:y>
    </cdr:from>
    <cdr:to>
      <cdr:x>0.231</cdr:x>
      <cdr:y>0.82059</cdr:y>
    </cdr:to>
    <cdr:cxnSp macro="">
      <cdr:nvCxnSpPr>
        <cdr:cNvPr id="16" name="Straight Connector 15"/>
        <cdr:cNvCxnSpPr/>
      </cdr:nvCxnSpPr>
      <cdr:spPr>
        <a:xfrm xmlns:a="http://schemas.openxmlformats.org/drawingml/2006/main">
          <a:off x="1152128" y="1296144"/>
          <a:ext cx="0" cy="1476000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3465</cdr:x>
      <cdr:y>0.38368</cdr:y>
    </cdr:from>
    <cdr:to>
      <cdr:x>0.3465</cdr:x>
      <cdr:y>0.82059</cdr:y>
    </cdr:to>
    <cdr:cxnSp macro="">
      <cdr:nvCxnSpPr>
        <cdr:cNvPr id="17" name="Straight Connector 16"/>
        <cdr:cNvCxnSpPr/>
      </cdr:nvCxnSpPr>
      <cdr:spPr>
        <a:xfrm xmlns:a="http://schemas.openxmlformats.org/drawingml/2006/main">
          <a:off x="1728192" y="1296144"/>
          <a:ext cx="0" cy="1476000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46199</cdr:x>
      <cdr:y>0.38368</cdr:y>
    </cdr:from>
    <cdr:to>
      <cdr:x>0.46199</cdr:x>
      <cdr:y>0.82059</cdr:y>
    </cdr:to>
    <cdr:cxnSp macro="">
      <cdr:nvCxnSpPr>
        <cdr:cNvPr id="18" name="Straight Connector 17"/>
        <cdr:cNvCxnSpPr/>
      </cdr:nvCxnSpPr>
      <cdr:spPr>
        <a:xfrm xmlns:a="http://schemas.openxmlformats.org/drawingml/2006/main">
          <a:off x="2304256" y="1296144"/>
          <a:ext cx="0" cy="1476000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AF10947-CEE0-439A-94E1-73494AD7A9D2}" type="datetimeFigureOut">
              <a:rPr lang="de-DE" smtClean="0"/>
              <a:t>29.04.2016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35B975-8E50-414B-87D9-5CA89AA4BA3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784884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1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KCNN4 and extracellular acidification. 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A)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Extracellular Acidification Rate measurements of Mia PaCa-2, 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B)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anc-1, 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C)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apan-1  and 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D)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BxPC-3 cells treated with rac-16 (KCNN4 inhibitor) at different concentrations as indicated, 100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M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NS309 (KCNN4 activator) and high concentrations of extracellular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KCl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60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M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, n=5. Data are represented as the mean ± SD. </a:t>
            </a:r>
            <a:r>
              <a:rPr lang="en-US" sz="1200" kern="1200" dirty="0" err="1" smtClean="0">
                <a:solidFill>
                  <a:srgbClr val="FF0000"/>
                </a:solidFill>
                <a:effectLst/>
                <a:latin typeface="+mn-lt"/>
                <a:ea typeface="+mn-ea"/>
                <a:cs typeface="+mn-cs"/>
              </a:rPr>
              <a:t>Bonferroni</a:t>
            </a:r>
            <a:r>
              <a:rPr lang="en-US" sz="1200" kern="1200" dirty="0" smtClean="0">
                <a:solidFill>
                  <a:srgbClr val="FF0000"/>
                </a:solidFill>
                <a:effectLst/>
                <a:latin typeface="+mn-lt"/>
                <a:ea typeface="+mn-ea"/>
                <a:cs typeface="+mn-cs"/>
              </a:rPr>
              <a:t> ANOVA test was performed to compare rates of DMSO-treated </a:t>
            </a:r>
            <a:r>
              <a:rPr lang="en-US" sz="1200" kern="1200" dirty="0" err="1" smtClean="0">
                <a:solidFill>
                  <a:srgbClr val="FF0000"/>
                </a:solidFill>
                <a:effectLst/>
                <a:latin typeface="+mn-lt"/>
                <a:ea typeface="+mn-ea"/>
                <a:cs typeface="+mn-cs"/>
              </a:rPr>
              <a:t>vs</a:t>
            </a:r>
            <a:r>
              <a:rPr lang="en-US" sz="1200" kern="1200" dirty="0" smtClean="0">
                <a:solidFill>
                  <a:srgbClr val="FF0000"/>
                </a:solidFill>
                <a:effectLst/>
                <a:latin typeface="+mn-lt"/>
                <a:ea typeface="+mn-ea"/>
                <a:cs typeface="+mn-cs"/>
              </a:rPr>
              <a:t> rac-16-treated</a:t>
            </a:r>
            <a:r>
              <a:rPr lang="en-US" sz="1200" kern="1200" baseline="0" dirty="0" smtClean="0">
                <a:solidFill>
                  <a:srgbClr val="FF0000"/>
                </a:solidFill>
                <a:effectLst/>
                <a:latin typeface="+mn-lt"/>
                <a:ea typeface="+mn-ea"/>
                <a:cs typeface="+mn-cs"/>
              </a:rPr>
              <a:t> cells at the time-point prior to </a:t>
            </a:r>
            <a:r>
              <a:rPr lang="en-US" sz="1200" kern="1200" baseline="0" smtClean="0">
                <a:solidFill>
                  <a:srgbClr val="FF0000"/>
                </a:solidFill>
                <a:effectLst/>
                <a:latin typeface="+mn-lt"/>
                <a:ea typeface="+mn-ea"/>
                <a:cs typeface="+mn-cs"/>
              </a:rPr>
              <a:t>NS309 injection; </a:t>
            </a:r>
            <a:r>
              <a:rPr lang="en-US" sz="1200" kern="1200" dirty="0" smtClean="0">
                <a:solidFill>
                  <a:srgbClr val="FF0000"/>
                </a:solidFill>
                <a:effectLst/>
                <a:latin typeface="+mn-lt"/>
                <a:ea typeface="+mn-ea"/>
                <a:cs typeface="+mn-cs"/>
              </a:rPr>
              <a:t>ns, not significant, p&gt;0.05,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*, p-value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s </a:t>
            </a:r>
            <a:r>
              <a:rPr lang="en-US" dirty="0" smtClean="0">
                <a:effectLst/>
              </a:rPr>
              <a:t>0.01 to 0.05; **, p-value </a:t>
            </a:r>
            <a:r>
              <a:rPr lang="en-US" smtClean="0">
                <a:effectLst/>
              </a:rPr>
              <a:t>is &lt; </a:t>
            </a:r>
            <a:r>
              <a:rPr lang="en-US" dirty="0" smtClean="0">
                <a:effectLst/>
              </a:rPr>
              <a:t>0.01.</a:t>
            </a:r>
            <a:endParaRPr lang="en-US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87F53A-C349-456C-A2FE-9F050B53FA04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9764440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2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KCNN4 hit confirmation. 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A)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Mia PaCa-2 cells transfected with siRNA against KCNN4, 20 000 cells/well were re-seeded one the night before the assay, upon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6 baseline measurements 10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μM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f rac-16 or 0.1% DMSO final concentration were injected to the media, n=6. T-test was performed to compare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iCRTR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DMSO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vs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iCTR-rac-16 and separately si4-DMSO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vs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 baseline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i4-rac-16 groups, **, p&lt; </a:t>
            </a:r>
            <a:r>
              <a:rPr lang="en-US" smtClean="0">
                <a:effectLst/>
              </a:rPr>
              <a:t>0.01.</a:t>
            </a:r>
            <a:endParaRPr lang="en-US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87F53A-C349-456C-A2FE-9F050B53FA04}" type="slidenum">
              <a:rPr lang="de-DE" smtClean="0"/>
              <a:t>2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9764440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Supplementary figure 3. Differential amplitude of Tram-34</a:t>
            </a:r>
            <a:r>
              <a:rPr lang="en-US" baseline="0" dirty="0" smtClean="0"/>
              <a:t> sensitive current  in the panel of PDAC cell lines. Analyses of the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hole-cell patch-clamp recordings in the presence of 1 µM free Ca</a:t>
            </a:r>
            <a:r>
              <a:rPr lang="en-US" sz="1200" kern="1200" baseline="30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2+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pipette solution at -5.8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mV potential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 Mia PaCa-2  (n=7), BxPC-3 (n=11)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anc-1 cells (n=7)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87F53A-C349-456C-A2FE-9F050B53FA04}" type="slidenum">
              <a:rPr lang="de-DE" smtClean="0"/>
              <a:t>3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9764440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5D3F70-FE0C-46CB-8D0B-462271139792}" type="datetimeFigureOut">
              <a:rPr lang="de-DE" smtClean="0"/>
              <a:t>29.04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F3C942-A265-41B2-B9E7-55CCBD3B61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418885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5D3F70-FE0C-46CB-8D0B-462271139792}" type="datetimeFigureOut">
              <a:rPr lang="de-DE" smtClean="0"/>
              <a:t>29.04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F3C942-A265-41B2-B9E7-55CCBD3B61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711729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5D3F70-FE0C-46CB-8D0B-462271139792}" type="datetimeFigureOut">
              <a:rPr lang="de-DE" smtClean="0"/>
              <a:t>29.04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F3C942-A265-41B2-B9E7-55CCBD3B61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080057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5D3F70-FE0C-46CB-8D0B-462271139792}" type="datetimeFigureOut">
              <a:rPr lang="de-DE" smtClean="0"/>
              <a:t>29.04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F3C942-A265-41B2-B9E7-55CCBD3B61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961202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5D3F70-FE0C-46CB-8D0B-462271139792}" type="datetimeFigureOut">
              <a:rPr lang="de-DE" smtClean="0"/>
              <a:t>29.04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F3C942-A265-41B2-B9E7-55CCBD3B61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16433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5D3F70-FE0C-46CB-8D0B-462271139792}" type="datetimeFigureOut">
              <a:rPr lang="de-DE" smtClean="0"/>
              <a:t>29.04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F3C942-A265-41B2-B9E7-55CCBD3B61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4081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5D3F70-FE0C-46CB-8D0B-462271139792}" type="datetimeFigureOut">
              <a:rPr lang="de-DE" smtClean="0"/>
              <a:t>29.04.2016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F3C942-A265-41B2-B9E7-55CCBD3B61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651198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5D3F70-FE0C-46CB-8D0B-462271139792}" type="datetimeFigureOut">
              <a:rPr lang="de-DE" smtClean="0"/>
              <a:t>29.04.2016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F3C942-A265-41B2-B9E7-55CCBD3B61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691217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5D3F70-FE0C-46CB-8D0B-462271139792}" type="datetimeFigureOut">
              <a:rPr lang="de-DE" smtClean="0"/>
              <a:t>29.04.2016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F3C942-A265-41B2-B9E7-55CCBD3B61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39434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5D3F70-FE0C-46CB-8D0B-462271139792}" type="datetimeFigureOut">
              <a:rPr lang="de-DE" smtClean="0"/>
              <a:t>29.04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F3C942-A265-41B2-B9E7-55CCBD3B61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157794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5D3F70-FE0C-46CB-8D0B-462271139792}" type="datetimeFigureOut">
              <a:rPr lang="de-DE" smtClean="0"/>
              <a:t>29.04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F3C942-A265-41B2-B9E7-55CCBD3B61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736178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5D3F70-FE0C-46CB-8D0B-462271139792}" type="datetimeFigureOut">
              <a:rPr lang="de-DE" smtClean="0"/>
              <a:t>29.04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F3C942-A265-41B2-B9E7-55CCBD3B61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470851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7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78168695"/>
              </p:ext>
            </p:extLst>
          </p:nvPr>
        </p:nvGraphicFramePr>
        <p:xfrm>
          <a:off x="-180528" y="620688"/>
          <a:ext cx="5059644" cy="33528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54063234"/>
              </p:ext>
            </p:extLst>
          </p:nvPr>
        </p:nvGraphicFramePr>
        <p:xfrm>
          <a:off x="35496" y="3372640"/>
          <a:ext cx="7056784" cy="33782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6829574"/>
              </p:ext>
            </p:extLst>
          </p:nvPr>
        </p:nvGraphicFramePr>
        <p:xfrm>
          <a:off x="5472608" y="3645024"/>
          <a:ext cx="4427984" cy="28083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18740828"/>
              </p:ext>
            </p:extLst>
          </p:nvPr>
        </p:nvGraphicFramePr>
        <p:xfrm>
          <a:off x="5364088" y="332656"/>
          <a:ext cx="4987636" cy="33782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35" name="TextBox 1"/>
          <p:cNvSpPr txBox="1"/>
          <p:nvPr/>
        </p:nvSpPr>
        <p:spPr>
          <a:xfrm>
            <a:off x="179512" y="1052736"/>
            <a:ext cx="234543" cy="3924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1800" b="1" dirty="0"/>
              <a:t>A</a:t>
            </a:r>
            <a:endParaRPr lang="de-DE" sz="1800" b="1" dirty="0"/>
          </a:p>
        </p:txBody>
      </p:sp>
      <p:sp>
        <p:nvSpPr>
          <p:cNvPr id="36" name="TextBox 1"/>
          <p:cNvSpPr txBox="1"/>
          <p:nvPr/>
        </p:nvSpPr>
        <p:spPr>
          <a:xfrm>
            <a:off x="5762291" y="1052736"/>
            <a:ext cx="2345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1800" b="1" dirty="0" smtClean="0"/>
              <a:t>B</a:t>
            </a:r>
            <a:endParaRPr lang="de-DE" sz="1800" b="1" dirty="0"/>
          </a:p>
        </p:txBody>
      </p:sp>
      <p:sp>
        <p:nvSpPr>
          <p:cNvPr id="41" name="TextBox 1"/>
          <p:cNvSpPr txBox="1"/>
          <p:nvPr/>
        </p:nvSpPr>
        <p:spPr>
          <a:xfrm>
            <a:off x="5762290" y="3717032"/>
            <a:ext cx="2345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1800" b="1" dirty="0" smtClean="0"/>
              <a:t>D</a:t>
            </a:r>
            <a:endParaRPr lang="de-DE" sz="18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-29885" y="0"/>
            <a:ext cx="24547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upplementary Figure 1</a:t>
            </a:r>
            <a:endParaRPr lang="de-DE" b="1" dirty="0"/>
          </a:p>
        </p:txBody>
      </p:sp>
      <p:pic>
        <p:nvPicPr>
          <p:cNvPr id="11" name="Picture 2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587" t="36656" r="5613" b="55778"/>
          <a:stretch/>
        </p:blipFill>
        <p:spPr bwMode="auto">
          <a:xfrm>
            <a:off x="3299297" y="6520484"/>
            <a:ext cx="2407909" cy="14887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0711960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-29885" y="0"/>
            <a:ext cx="24550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upplementary Figure 2</a:t>
            </a:r>
            <a:endParaRPr lang="de-DE" b="1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38387" y="1196752"/>
            <a:ext cx="4486275" cy="3648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Right Bracket 1"/>
          <p:cNvSpPr/>
          <p:nvPr/>
        </p:nvSpPr>
        <p:spPr>
          <a:xfrm rot="16200000">
            <a:off x="3829060" y="1507644"/>
            <a:ext cx="45721" cy="1152129"/>
          </a:xfrm>
          <a:prstGeom prst="righ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TextBox 2"/>
          <p:cNvSpPr txBox="1"/>
          <p:nvPr/>
        </p:nvSpPr>
        <p:spPr>
          <a:xfrm>
            <a:off x="3707904" y="1916832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**</a:t>
            </a:r>
            <a:endParaRPr lang="en-US" sz="1000" dirty="0"/>
          </a:p>
        </p:txBody>
      </p:sp>
      <p:sp>
        <p:nvSpPr>
          <p:cNvPr id="6" name="Right Bracket 5"/>
          <p:cNvSpPr/>
          <p:nvPr/>
        </p:nvSpPr>
        <p:spPr>
          <a:xfrm rot="16200000">
            <a:off x="4405124" y="1693471"/>
            <a:ext cx="45721" cy="1152129"/>
          </a:xfrm>
          <a:prstGeom prst="righ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/>
          <p:cNvSpPr txBox="1"/>
          <p:nvPr/>
        </p:nvSpPr>
        <p:spPr>
          <a:xfrm>
            <a:off x="4283968" y="2102659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**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4933139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-29885" y="0"/>
            <a:ext cx="24550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upplementary Figure 3</a:t>
            </a:r>
            <a:endParaRPr lang="de-DE" b="1" dirty="0"/>
          </a:p>
        </p:txBody>
      </p:sp>
      <p:pic>
        <p:nvPicPr>
          <p:cNvPr id="4" name="Picture 2" descr="mac:Users:dravery:Google Drive:BILDER:K+:TRAM-sens at -5.8mV.jpg"/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15627" y="2303145"/>
            <a:ext cx="2912745" cy="2251710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TextBox 1"/>
          <p:cNvSpPr txBox="1"/>
          <p:nvPr/>
        </p:nvSpPr>
        <p:spPr>
          <a:xfrm>
            <a:off x="4507200" y="2924941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*</a:t>
            </a:r>
            <a:endParaRPr lang="en-US" sz="1000" dirty="0"/>
          </a:p>
        </p:txBody>
      </p:sp>
      <p:sp>
        <p:nvSpPr>
          <p:cNvPr id="5" name="TextBox 4"/>
          <p:cNvSpPr txBox="1"/>
          <p:nvPr/>
        </p:nvSpPr>
        <p:spPr>
          <a:xfrm>
            <a:off x="5171394" y="2564903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*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2576767548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11</Words>
  <Application>Microsoft Office PowerPoint</Application>
  <PresentationFormat>Bildschirmpräsentation (4:3)</PresentationFormat>
  <Paragraphs>29</Paragraphs>
  <Slides>3</Slides>
  <Notes>3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4" baseType="lpstr">
      <vt:lpstr>Larissa</vt:lpstr>
      <vt:lpstr>PowerPoint-Präsentation</vt:lpstr>
      <vt:lpstr>PowerPoint-Präsentation</vt:lpstr>
      <vt:lpstr>PowerPoint-Präsentation</vt:lpstr>
    </vt:vector>
  </TitlesOfParts>
  <Company>Bay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ven Christian</dc:creator>
  <cp:lastModifiedBy>Sven Christian</cp:lastModifiedBy>
  <cp:revision>14</cp:revision>
  <dcterms:created xsi:type="dcterms:W3CDTF">2015-09-15T07:18:11Z</dcterms:created>
  <dcterms:modified xsi:type="dcterms:W3CDTF">2016-04-29T07:19:04Z</dcterms:modified>
</cp:coreProperties>
</file>